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8"/>
  </p:notesMasterIdLst>
  <p:sldIdLst>
    <p:sldId id="11014" r:id="rId5"/>
    <p:sldId id="11015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usrat, Maliha" userId="a31d8097-5b96-41b0-aa10-ed137cff77b8" providerId="ADAL" clId="{05F67E2A-393B-4C67-93BE-E9A376C25F66}"/>
    <pc:docChg chg="modSld">
      <pc:chgData name="Nusrat, Maliha" userId="a31d8097-5b96-41b0-aa10-ed137cff77b8" providerId="ADAL" clId="{05F67E2A-393B-4C67-93BE-E9A376C25F66}" dt="2025-10-13T23:09:04.255" v="0" actId="20577"/>
      <pc:docMkLst>
        <pc:docMk/>
      </pc:docMkLst>
      <pc:sldChg chg="modSp mod">
        <pc:chgData name="Nusrat, Maliha" userId="a31d8097-5b96-41b0-aa10-ed137cff77b8" providerId="ADAL" clId="{05F67E2A-393B-4C67-93BE-E9A376C25F66}" dt="2025-10-13T23:09:04.255" v="0" actId="20577"/>
        <pc:sldMkLst>
          <pc:docMk/>
          <pc:sldMk cId="422834193" sldId="11014"/>
        </pc:sldMkLst>
        <pc:spChg chg="mod">
          <ac:chgData name="Nusrat, Maliha" userId="a31d8097-5b96-41b0-aa10-ed137cff77b8" providerId="ADAL" clId="{05F67E2A-393B-4C67-93BE-E9A376C25F66}" dt="2025-10-13T23:09:04.255" v="0" actId="20577"/>
          <ac:spMkLst>
            <pc:docMk/>
            <pc:sldMk cId="422834193" sldId="11014"/>
            <ac:spMk id="105" creationId="{4A6E75F6-F946-A3D4-18CC-E6FFB35E1212}"/>
          </ac:spMkLst>
        </pc:spChg>
      </pc:sldChg>
    </pc:docChg>
  </pc:docChgLst>
  <pc:docChgLst>
    <pc:chgData name="Nusrat, Maliha" userId="a31d8097-5b96-41b0-aa10-ed137cff77b8" providerId="ADAL" clId="{B21DD364-83F4-46A5-B803-47C6C4625EE8}"/>
    <pc:docChg chg="delSld modSld">
      <pc:chgData name="Nusrat, Maliha" userId="a31d8097-5b96-41b0-aa10-ed137cff77b8" providerId="ADAL" clId="{B21DD364-83F4-46A5-B803-47C6C4625EE8}" dt="2025-04-30T19:13:12.204" v="6" actId="47"/>
      <pc:docMkLst>
        <pc:docMk/>
      </pc:docMkLst>
      <pc:sldChg chg="modSp del mod">
        <pc:chgData name="Nusrat, Maliha" userId="a31d8097-5b96-41b0-aa10-ed137cff77b8" providerId="ADAL" clId="{B21DD364-83F4-46A5-B803-47C6C4625EE8}" dt="2025-04-30T19:13:12.204" v="6" actId="47"/>
        <pc:sldMkLst>
          <pc:docMk/>
          <pc:sldMk cId="104329144" sldId="11016"/>
        </pc:sldMkLst>
        <pc:graphicFrameChg chg="modGraphic">
          <ac:chgData name="Nusrat, Maliha" userId="a31d8097-5b96-41b0-aa10-ed137cff77b8" providerId="ADAL" clId="{B21DD364-83F4-46A5-B803-47C6C4625EE8}" dt="2025-04-30T18:52:08.696" v="5" actId="20577"/>
          <ac:graphicFrameMkLst>
            <pc:docMk/>
            <pc:sldMk cId="104329144" sldId="11016"/>
            <ac:graphicFrameMk id="2" creationId="{5EF2501B-284B-27BB-82BD-DBBB396F6489}"/>
          </ac:graphicFrameMkLst>
        </pc:graphicFrameChg>
      </pc:sldChg>
    </pc:docChg>
  </pc:docChgLst>
  <pc:docChgLst>
    <pc:chgData name="Nusrat, Maliha" userId="a31d8097-5b96-41b0-aa10-ed137cff77b8" providerId="ADAL" clId="{0FF8CDD8-5323-437D-9F1F-CE55364BF4F1}"/>
    <pc:docChg chg="undo custSel modSld">
      <pc:chgData name="Nusrat, Maliha" userId="a31d8097-5b96-41b0-aa10-ed137cff77b8" providerId="ADAL" clId="{0FF8CDD8-5323-437D-9F1F-CE55364BF4F1}" dt="2025-03-21T05:12:58.526" v="27" actId="1036"/>
      <pc:docMkLst>
        <pc:docMk/>
      </pc:docMkLst>
      <pc:sldChg chg="modSp mod">
        <pc:chgData name="Nusrat, Maliha" userId="a31d8097-5b96-41b0-aa10-ed137cff77b8" providerId="ADAL" clId="{0FF8CDD8-5323-437D-9F1F-CE55364BF4F1}" dt="2025-03-21T05:12:58.526" v="27" actId="1036"/>
        <pc:sldMkLst>
          <pc:docMk/>
          <pc:sldMk cId="104329144" sldId="11016"/>
        </pc:sldMkLst>
        <pc:spChg chg="mod">
          <ac:chgData name="Nusrat, Maliha" userId="a31d8097-5b96-41b0-aa10-ed137cff77b8" providerId="ADAL" clId="{0FF8CDD8-5323-437D-9F1F-CE55364BF4F1}" dt="2025-03-21T05:12:58.526" v="27" actId="1036"/>
          <ac:spMkLst>
            <pc:docMk/>
            <pc:sldMk cId="104329144" sldId="11016"/>
            <ac:spMk id="4" creationId="{1C422B62-428C-2843-3E3C-8ABD7653BD01}"/>
          </ac:spMkLst>
        </pc:spChg>
        <pc:spChg chg="mod">
          <ac:chgData name="Nusrat, Maliha" userId="a31d8097-5b96-41b0-aa10-ed137cff77b8" providerId="ADAL" clId="{0FF8CDD8-5323-437D-9F1F-CE55364BF4F1}" dt="2025-03-21T05:12:58.526" v="27" actId="1036"/>
          <ac:spMkLst>
            <pc:docMk/>
            <pc:sldMk cId="104329144" sldId="11016"/>
            <ac:spMk id="8" creationId="{7FE7595C-1F42-4E77-3F06-C4D3EC3144EC}"/>
          </ac:spMkLst>
        </pc:spChg>
        <pc:graphicFrameChg chg="mod">
          <ac:chgData name="Nusrat, Maliha" userId="a31d8097-5b96-41b0-aa10-ed137cff77b8" providerId="ADAL" clId="{0FF8CDD8-5323-437D-9F1F-CE55364BF4F1}" dt="2025-03-21T05:12:58.526" v="27" actId="1036"/>
          <ac:graphicFrameMkLst>
            <pc:docMk/>
            <pc:sldMk cId="104329144" sldId="11016"/>
            <ac:graphicFrameMk id="2" creationId="{5EF2501B-284B-27BB-82BD-DBBB396F6489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4B9208-3B02-49A0-95E8-B569CCFE3B0C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6332B2-5CF6-43FC-8CA5-BA3C1D4E77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31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635306-B3B1-A944-A64E-0A77BF93790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29914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7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svg"/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phic 9">
            <a:extLst>
              <a:ext uri="{FF2B5EF4-FFF2-40B4-BE49-F238E27FC236}">
                <a16:creationId xmlns:a16="http://schemas.microsoft.com/office/drawing/2014/main" id="{C5E47407-2EC8-524C-85CD-E0BC1A1C8F1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739AB803-A532-384B-A53A-B6D4C36E506C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1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5A9A0FEB-2318-1E41-A04B-A702497639C9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1655357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Blue 1/2 Image ODL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E176EC07-7590-9014-296C-172578C5C04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6" y="1371600"/>
            <a:ext cx="5131970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E8ECE2AD-E262-0244-A779-32BC5B97C66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316082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Divider Layouts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2690335"/>
            <a:ext cx="12191999" cy="1477328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Divider layouts</a:t>
            </a:r>
          </a:p>
        </p:txBody>
      </p:sp>
    </p:spTree>
    <p:extLst>
      <p:ext uri="{BB962C8B-B14F-4D97-AF65-F5344CB8AC3E}">
        <p14:creationId xmlns:p14="http://schemas.microsoft.com/office/powerpoint/2010/main" val="16768928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Freeform 14">
            <a:extLst>
              <a:ext uri="{FF2B5EF4-FFF2-40B4-BE49-F238E27FC236}">
                <a16:creationId xmlns:a16="http://schemas.microsoft.com/office/drawing/2014/main" id="{6D86FA2C-F8A6-90E8-5782-DF29638FC6C0}"/>
              </a:ext>
            </a:extLst>
          </p:cNvPr>
          <p:cNvSpPr/>
          <p:nvPr/>
        </p:nvSpPr>
        <p:spPr>
          <a:xfrm>
            <a:off x="6428802" y="483936"/>
            <a:ext cx="5763198" cy="6374064"/>
          </a:xfrm>
          <a:custGeom>
            <a:avLst/>
            <a:gdLst>
              <a:gd name="connsiteX0" fmla="*/ 3554522 w 5763198"/>
              <a:gd name="connsiteY0" fmla="*/ 1277148 h 6374064"/>
              <a:gd name="connsiteX1" fmla="*/ 4965198 w 5763198"/>
              <a:gd name="connsiteY1" fmla="*/ 2685220 h 6374064"/>
              <a:gd name="connsiteX2" fmla="*/ 4638987 w 5763198"/>
              <a:gd name="connsiteY2" fmla="*/ 3010816 h 6374064"/>
              <a:gd name="connsiteX3" fmla="*/ 3785164 w 5763198"/>
              <a:gd name="connsiteY3" fmla="*/ 2158571 h 6374064"/>
              <a:gd name="connsiteX4" fmla="*/ 3785164 w 5763198"/>
              <a:gd name="connsiteY4" fmla="*/ 3610576 h 6374064"/>
              <a:gd name="connsiteX5" fmla="*/ 4797652 w 5763198"/>
              <a:gd name="connsiteY5" fmla="*/ 3610576 h 6374064"/>
              <a:gd name="connsiteX6" fmla="*/ 4797652 w 5763198"/>
              <a:gd name="connsiteY6" fmla="*/ 4071018 h 6374064"/>
              <a:gd name="connsiteX7" fmla="*/ 3785164 w 5763198"/>
              <a:gd name="connsiteY7" fmla="*/ 4071018 h 6374064"/>
              <a:gd name="connsiteX8" fmla="*/ 3785164 w 5763198"/>
              <a:gd name="connsiteY8" fmla="*/ 4427325 h 6374064"/>
              <a:gd name="connsiteX9" fmla="*/ 4797652 w 5763198"/>
              <a:gd name="connsiteY9" fmla="*/ 4427325 h 6374064"/>
              <a:gd name="connsiteX10" fmla="*/ 4797652 w 5763198"/>
              <a:gd name="connsiteY10" fmla="*/ 4887800 h 6374064"/>
              <a:gd name="connsiteX11" fmla="*/ 3785164 w 5763198"/>
              <a:gd name="connsiteY11" fmla="*/ 4887800 h 6374064"/>
              <a:gd name="connsiteX12" fmla="*/ 3785164 w 5763198"/>
              <a:gd name="connsiteY12" fmla="*/ 5244106 h 6374064"/>
              <a:gd name="connsiteX13" fmla="*/ 4797652 w 5763198"/>
              <a:gd name="connsiteY13" fmla="*/ 5244106 h 6374064"/>
              <a:gd name="connsiteX14" fmla="*/ 4797652 w 5763198"/>
              <a:gd name="connsiteY14" fmla="*/ 5704548 h 6374064"/>
              <a:gd name="connsiteX15" fmla="*/ 3785164 w 5763198"/>
              <a:gd name="connsiteY15" fmla="*/ 5704548 h 6374064"/>
              <a:gd name="connsiteX16" fmla="*/ 3785164 w 5763198"/>
              <a:gd name="connsiteY16" fmla="*/ 6374064 h 6374064"/>
              <a:gd name="connsiteX17" fmla="*/ 3323858 w 5763198"/>
              <a:gd name="connsiteY17" fmla="*/ 6374064 h 6374064"/>
              <a:gd name="connsiteX18" fmla="*/ 3323858 w 5763198"/>
              <a:gd name="connsiteY18" fmla="*/ 5704548 h 6374064"/>
              <a:gd name="connsiteX19" fmla="*/ 2311348 w 5763198"/>
              <a:gd name="connsiteY19" fmla="*/ 5704548 h 6374064"/>
              <a:gd name="connsiteX20" fmla="*/ 2311348 w 5763198"/>
              <a:gd name="connsiteY20" fmla="*/ 5244106 h 6374064"/>
              <a:gd name="connsiteX21" fmla="*/ 3323858 w 5763198"/>
              <a:gd name="connsiteY21" fmla="*/ 5244106 h 6374064"/>
              <a:gd name="connsiteX22" fmla="*/ 3323858 w 5763198"/>
              <a:gd name="connsiteY22" fmla="*/ 4887800 h 6374064"/>
              <a:gd name="connsiteX23" fmla="*/ 2311348 w 5763198"/>
              <a:gd name="connsiteY23" fmla="*/ 4887800 h 6374064"/>
              <a:gd name="connsiteX24" fmla="*/ 2311348 w 5763198"/>
              <a:gd name="connsiteY24" fmla="*/ 4427325 h 6374064"/>
              <a:gd name="connsiteX25" fmla="*/ 3323858 w 5763198"/>
              <a:gd name="connsiteY25" fmla="*/ 4427325 h 6374064"/>
              <a:gd name="connsiteX26" fmla="*/ 3323858 w 5763198"/>
              <a:gd name="connsiteY26" fmla="*/ 4071018 h 6374064"/>
              <a:gd name="connsiteX27" fmla="*/ 2311348 w 5763198"/>
              <a:gd name="connsiteY27" fmla="*/ 4071018 h 6374064"/>
              <a:gd name="connsiteX28" fmla="*/ 2311348 w 5763198"/>
              <a:gd name="connsiteY28" fmla="*/ 3610576 h 6374064"/>
              <a:gd name="connsiteX29" fmla="*/ 3323858 w 5763198"/>
              <a:gd name="connsiteY29" fmla="*/ 3610576 h 6374064"/>
              <a:gd name="connsiteX30" fmla="*/ 3323858 w 5763198"/>
              <a:gd name="connsiteY30" fmla="*/ 2158603 h 6374064"/>
              <a:gd name="connsiteX31" fmla="*/ 2470036 w 5763198"/>
              <a:gd name="connsiteY31" fmla="*/ 3010816 h 6374064"/>
              <a:gd name="connsiteX32" fmla="*/ 2143825 w 5763198"/>
              <a:gd name="connsiteY32" fmla="*/ 2685220 h 6374064"/>
              <a:gd name="connsiteX33" fmla="*/ 3554490 w 5763198"/>
              <a:gd name="connsiteY33" fmla="*/ 0 h 6374064"/>
              <a:gd name="connsiteX34" fmla="*/ 5714575 w 5763198"/>
              <a:gd name="connsiteY34" fmla="*/ 582998 h 6374064"/>
              <a:gd name="connsiteX35" fmla="*/ 5763198 w 5763198"/>
              <a:gd name="connsiteY35" fmla="*/ 618804 h 6374064"/>
              <a:gd name="connsiteX36" fmla="*/ 5763198 w 5763198"/>
              <a:gd name="connsiteY36" fmla="*/ 1232611 h 6374064"/>
              <a:gd name="connsiteX37" fmla="*/ 5668108 w 5763198"/>
              <a:gd name="connsiteY37" fmla="*/ 1136723 h 6374064"/>
              <a:gd name="connsiteX38" fmla="*/ 3554490 w 5763198"/>
              <a:gd name="connsiteY38" fmla="*/ 460367 h 6374064"/>
              <a:gd name="connsiteX39" fmla="*/ 462581 w 5763198"/>
              <a:gd name="connsiteY39" fmla="*/ 3993976 h 6374064"/>
              <a:gd name="connsiteX40" fmla="*/ 897378 w 5763198"/>
              <a:gd name="connsiteY40" fmla="*/ 6147274 h 6374064"/>
              <a:gd name="connsiteX41" fmla="*/ 1033153 w 5763198"/>
              <a:gd name="connsiteY41" fmla="*/ 6374064 h 6374064"/>
              <a:gd name="connsiteX42" fmla="*/ 493028 w 5763198"/>
              <a:gd name="connsiteY42" fmla="*/ 6374064 h 6374064"/>
              <a:gd name="connsiteX43" fmla="*/ 348006 w 5763198"/>
              <a:gd name="connsiteY43" fmla="*/ 6063412 h 6374064"/>
              <a:gd name="connsiteX44" fmla="*/ 0 w 5763198"/>
              <a:gd name="connsiteY44" fmla="*/ 3993976 h 6374064"/>
              <a:gd name="connsiteX45" fmla="*/ 887775 w 5763198"/>
              <a:gd name="connsiteY45" fmla="*/ 1034018 h 6374064"/>
              <a:gd name="connsiteX46" fmla="*/ 3554490 w 5763198"/>
              <a:gd name="connsiteY46" fmla="*/ 0 h 63740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5763198" h="6374064">
                <a:moveTo>
                  <a:pt x="3554522" y="1277148"/>
                </a:moveTo>
                <a:lnTo>
                  <a:pt x="4965198" y="2685220"/>
                </a:lnTo>
                <a:lnTo>
                  <a:pt x="4638987" y="3010816"/>
                </a:lnTo>
                <a:lnTo>
                  <a:pt x="3785164" y="2158571"/>
                </a:lnTo>
                <a:lnTo>
                  <a:pt x="3785164" y="3610576"/>
                </a:lnTo>
                <a:lnTo>
                  <a:pt x="4797652" y="3610576"/>
                </a:lnTo>
                <a:lnTo>
                  <a:pt x="4797652" y="4071018"/>
                </a:lnTo>
                <a:lnTo>
                  <a:pt x="3785164" y="4071018"/>
                </a:lnTo>
                <a:lnTo>
                  <a:pt x="3785164" y="4427325"/>
                </a:lnTo>
                <a:lnTo>
                  <a:pt x="4797652" y="4427325"/>
                </a:lnTo>
                <a:lnTo>
                  <a:pt x="4797652" y="4887800"/>
                </a:lnTo>
                <a:lnTo>
                  <a:pt x="3785164" y="4887800"/>
                </a:lnTo>
                <a:lnTo>
                  <a:pt x="3785164" y="5244106"/>
                </a:lnTo>
                <a:lnTo>
                  <a:pt x="4797652" y="5244106"/>
                </a:lnTo>
                <a:lnTo>
                  <a:pt x="4797652" y="5704548"/>
                </a:lnTo>
                <a:lnTo>
                  <a:pt x="3785164" y="5704548"/>
                </a:lnTo>
                <a:lnTo>
                  <a:pt x="3785164" y="6374064"/>
                </a:lnTo>
                <a:lnTo>
                  <a:pt x="3323858" y="6374064"/>
                </a:lnTo>
                <a:lnTo>
                  <a:pt x="3323858" y="5704548"/>
                </a:lnTo>
                <a:lnTo>
                  <a:pt x="2311348" y="5704548"/>
                </a:lnTo>
                <a:lnTo>
                  <a:pt x="2311348" y="5244106"/>
                </a:lnTo>
                <a:lnTo>
                  <a:pt x="3323858" y="5244106"/>
                </a:lnTo>
                <a:lnTo>
                  <a:pt x="3323858" y="4887800"/>
                </a:lnTo>
                <a:lnTo>
                  <a:pt x="2311348" y="4887800"/>
                </a:lnTo>
                <a:lnTo>
                  <a:pt x="2311348" y="4427325"/>
                </a:lnTo>
                <a:lnTo>
                  <a:pt x="3323858" y="4427325"/>
                </a:lnTo>
                <a:lnTo>
                  <a:pt x="3323858" y="4071018"/>
                </a:lnTo>
                <a:lnTo>
                  <a:pt x="2311348" y="4071018"/>
                </a:lnTo>
                <a:lnTo>
                  <a:pt x="2311348" y="3610576"/>
                </a:lnTo>
                <a:lnTo>
                  <a:pt x="3323858" y="3610576"/>
                </a:lnTo>
                <a:lnTo>
                  <a:pt x="3323858" y="2158603"/>
                </a:lnTo>
                <a:lnTo>
                  <a:pt x="2470036" y="3010816"/>
                </a:lnTo>
                <a:lnTo>
                  <a:pt x="2143825" y="2685220"/>
                </a:lnTo>
                <a:close/>
                <a:moveTo>
                  <a:pt x="3554490" y="0"/>
                </a:moveTo>
                <a:cubicBezTo>
                  <a:pt x="4429874" y="0"/>
                  <a:pt x="5153422" y="195695"/>
                  <a:pt x="5714575" y="582998"/>
                </a:cubicBezTo>
                <a:lnTo>
                  <a:pt x="5763198" y="618804"/>
                </a:lnTo>
                <a:lnTo>
                  <a:pt x="5763198" y="1232611"/>
                </a:lnTo>
                <a:lnTo>
                  <a:pt x="5668108" y="1136723"/>
                </a:lnTo>
                <a:cubicBezTo>
                  <a:pt x="5160837" y="685819"/>
                  <a:pt x="4456297" y="460367"/>
                  <a:pt x="3554490" y="460367"/>
                </a:cubicBezTo>
                <a:cubicBezTo>
                  <a:pt x="1493207" y="460367"/>
                  <a:pt x="462581" y="1638240"/>
                  <a:pt x="462581" y="3993976"/>
                </a:cubicBezTo>
                <a:cubicBezTo>
                  <a:pt x="462581" y="4877377"/>
                  <a:pt x="607513" y="5595144"/>
                  <a:pt x="897378" y="6147274"/>
                </a:cubicBezTo>
                <a:lnTo>
                  <a:pt x="1033153" y="6374064"/>
                </a:lnTo>
                <a:lnTo>
                  <a:pt x="493028" y="6374064"/>
                </a:lnTo>
                <a:lnTo>
                  <a:pt x="348006" y="6063412"/>
                </a:lnTo>
                <a:cubicBezTo>
                  <a:pt x="116679" y="5494171"/>
                  <a:pt x="0" y="4802111"/>
                  <a:pt x="0" y="3993976"/>
                </a:cubicBezTo>
                <a:cubicBezTo>
                  <a:pt x="0" y="2700970"/>
                  <a:pt x="298698" y="1705096"/>
                  <a:pt x="887775" y="1034018"/>
                </a:cubicBezTo>
                <a:cubicBezTo>
                  <a:pt x="1490095" y="347903"/>
                  <a:pt x="2387300" y="0"/>
                  <a:pt x="3554490" y="0"/>
                </a:cubicBezTo>
                <a:close/>
              </a:path>
            </a:pathLst>
          </a:custGeom>
          <a:solidFill>
            <a:schemeClr val="accent2">
              <a:alpha val="25000"/>
            </a:schemeClr>
          </a:solidFill>
          <a:ln w="3001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0CE4FF-62C5-5C44-AE4A-3D38634FF8CF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3278743C-5E55-7D4C-9CFF-3A25EB7EE36F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04825" y="1371600"/>
            <a:ext cx="7419975" cy="4718050"/>
          </a:xfrm>
        </p:spPr>
        <p:txBody>
          <a:bodyPr vert="horz" anchor="ctr"/>
          <a:lstStyle>
            <a:lvl1pPr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This slide is for a divider, statement or takeaway.</a:t>
            </a:r>
          </a:p>
        </p:txBody>
      </p:sp>
    </p:spTree>
    <p:extLst>
      <p:ext uri="{BB962C8B-B14F-4D97-AF65-F5344CB8AC3E}">
        <p14:creationId xmlns:p14="http://schemas.microsoft.com/office/powerpoint/2010/main" val="38980461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Header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 10">
            <a:extLst>
              <a:ext uri="{FF2B5EF4-FFF2-40B4-BE49-F238E27FC236}">
                <a16:creationId xmlns:a16="http://schemas.microsoft.com/office/drawing/2014/main" id="{666FADEA-3B1D-38EC-A06D-527B0A9E3ADB}"/>
              </a:ext>
            </a:extLst>
          </p:cNvPr>
          <p:cNvSpPr/>
          <p:nvPr/>
        </p:nvSpPr>
        <p:spPr>
          <a:xfrm>
            <a:off x="6428802" y="483936"/>
            <a:ext cx="5763198" cy="6374064"/>
          </a:xfrm>
          <a:custGeom>
            <a:avLst/>
            <a:gdLst>
              <a:gd name="connsiteX0" fmla="*/ 3554522 w 5763198"/>
              <a:gd name="connsiteY0" fmla="*/ 1277148 h 6374064"/>
              <a:gd name="connsiteX1" fmla="*/ 4965198 w 5763198"/>
              <a:gd name="connsiteY1" fmla="*/ 2685220 h 6374064"/>
              <a:gd name="connsiteX2" fmla="*/ 4638987 w 5763198"/>
              <a:gd name="connsiteY2" fmla="*/ 3010816 h 6374064"/>
              <a:gd name="connsiteX3" fmla="*/ 3785164 w 5763198"/>
              <a:gd name="connsiteY3" fmla="*/ 2158571 h 6374064"/>
              <a:gd name="connsiteX4" fmla="*/ 3785164 w 5763198"/>
              <a:gd name="connsiteY4" fmla="*/ 3610576 h 6374064"/>
              <a:gd name="connsiteX5" fmla="*/ 4797652 w 5763198"/>
              <a:gd name="connsiteY5" fmla="*/ 3610576 h 6374064"/>
              <a:gd name="connsiteX6" fmla="*/ 4797652 w 5763198"/>
              <a:gd name="connsiteY6" fmla="*/ 4071018 h 6374064"/>
              <a:gd name="connsiteX7" fmla="*/ 3785164 w 5763198"/>
              <a:gd name="connsiteY7" fmla="*/ 4071018 h 6374064"/>
              <a:gd name="connsiteX8" fmla="*/ 3785164 w 5763198"/>
              <a:gd name="connsiteY8" fmla="*/ 4427325 h 6374064"/>
              <a:gd name="connsiteX9" fmla="*/ 4797652 w 5763198"/>
              <a:gd name="connsiteY9" fmla="*/ 4427325 h 6374064"/>
              <a:gd name="connsiteX10" fmla="*/ 4797652 w 5763198"/>
              <a:gd name="connsiteY10" fmla="*/ 4887800 h 6374064"/>
              <a:gd name="connsiteX11" fmla="*/ 3785164 w 5763198"/>
              <a:gd name="connsiteY11" fmla="*/ 4887800 h 6374064"/>
              <a:gd name="connsiteX12" fmla="*/ 3785164 w 5763198"/>
              <a:gd name="connsiteY12" fmla="*/ 5244106 h 6374064"/>
              <a:gd name="connsiteX13" fmla="*/ 4797652 w 5763198"/>
              <a:gd name="connsiteY13" fmla="*/ 5244106 h 6374064"/>
              <a:gd name="connsiteX14" fmla="*/ 4797652 w 5763198"/>
              <a:gd name="connsiteY14" fmla="*/ 5704548 h 6374064"/>
              <a:gd name="connsiteX15" fmla="*/ 3785164 w 5763198"/>
              <a:gd name="connsiteY15" fmla="*/ 5704548 h 6374064"/>
              <a:gd name="connsiteX16" fmla="*/ 3785164 w 5763198"/>
              <a:gd name="connsiteY16" fmla="*/ 6374064 h 6374064"/>
              <a:gd name="connsiteX17" fmla="*/ 3323858 w 5763198"/>
              <a:gd name="connsiteY17" fmla="*/ 6374064 h 6374064"/>
              <a:gd name="connsiteX18" fmla="*/ 3323858 w 5763198"/>
              <a:gd name="connsiteY18" fmla="*/ 5704548 h 6374064"/>
              <a:gd name="connsiteX19" fmla="*/ 2311348 w 5763198"/>
              <a:gd name="connsiteY19" fmla="*/ 5704548 h 6374064"/>
              <a:gd name="connsiteX20" fmla="*/ 2311348 w 5763198"/>
              <a:gd name="connsiteY20" fmla="*/ 5244106 h 6374064"/>
              <a:gd name="connsiteX21" fmla="*/ 3323858 w 5763198"/>
              <a:gd name="connsiteY21" fmla="*/ 5244106 h 6374064"/>
              <a:gd name="connsiteX22" fmla="*/ 3323858 w 5763198"/>
              <a:gd name="connsiteY22" fmla="*/ 4887800 h 6374064"/>
              <a:gd name="connsiteX23" fmla="*/ 2311348 w 5763198"/>
              <a:gd name="connsiteY23" fmla="*/ 4887800 h 6374064"/>
              <a:gd name="connsiteX24" fmla="*/ 2311348 w 5763198"/>
              <a:gd name="connsiteY24" fmla="*/ 4427325 h 6374064"/>
              <a:gd name="connsiteX25" fmla="*/ 3323858 w 5763198"/>
              <a:gd name="connsiteY25" fmla="*/ 4427325 h 6374064"/>
              <a:gd name="connsiteX26" fmla="*/ 3323858 w 5763198"/>
              <a:gd name="connsiteY26" fmla="*/ 4071018 h 6374064"/>
              <a:gd name="connsiteX27" fmla="*/ 2311348 w 5763198"/>
              <a:gd name="connsiteY27" fmla="*/ 4071018 h 6374064"/>
              <a:gd name="connsiteX28" fmla="*/ 2311348 w 5763198"/>
              <a:gd name="connsiteY28" fmla="*/ 3610576 h 6374064"/>
              <a:gd name="connsiteX29" fmla="*/ 3323858 w 5763198"/>
              <a:gd name="connsiteY29" fmla="*/ 3610576 h 6374064"/>
              <a:gd name="connsiteX30" fmla="*/ 3323858 w 5763198"/>
              <a:gd name="connsiteY30" fmla="*/ 2158603 h 6374064"/>
              <a:gd name="connsiteX31" fmla="*/ 2470036 w 5763198"/>
              <a:gd name="connsiteY31" fmla="*/ 3010816 h 6374064"/>
              <a:gd name="connsiteX32" fmla="*/ 2143825 w 5763198"/>
              <a:gd name="connsiteY32" fmla="*/ 2685220 h 6374064"/>
              <a:gd name="connsiteX33" fmla="*/ 3554490 w 5763198"/>
              <a:gd name="connsiteY33" fmla="*/ 0 h 6374064"/>
              <a:gd name="connsiteX34" fmla="*/ 5714575 w 5763198"/>
              <a:gd name="connsiteY34" fmla="*/ 582998 h 6374064"/>
              <a:gd name="connsiteX35" fmla="*/ 5763198 w 5763198"/>
              <a:gd name="connsiteY35" fmla="*/ 618804 h 6374064"/>
              <a:gd name="connsiteX36" fmla="*/ 5763198 w 5763198"/>
              <a:gd name="connsiteY36" fmla="*/ 1232611 h 6374064"/>
              <a:gd name="connsiteX37" fmla="*/ 5668108 w 5763198"/>
              <a:gd name="connsiteY37" fmla="*/ 1136723 h 6374064"/>
              <a:gd name="connsiteX38" fmla="*/ 3554490 w 5763198"/>
              <a:gd name="connsiteY38" fmla="*/ 460367 h 6374064"/>
              <a:gd name="connsiteX39" fmla="*/ 462581 w 5763198"/>
              <a:gd name="connsiteY39" fmla="*/ 3993976 h 6374064"/>
              <a:gd name="connsiteX40" fmla="*/ 897378 w 5763198"/>
              <a:gd name="connsiteY40" fmla="*/ 6147274 h 6374064"/>
              <a:gd name="connsiteX41" fmla="*/ 1033153 w 5763198"/>
              <a:gd name="connsiteY41" fmla="*/ 6374064 h 6374064"/>
              <a:gd name="connsiteX42" fmla="*/ 493028 w 5763198"/>
              <a:gd name="connsiteY42" fmla="*/ 6374064 h 6374064"/>
              <a:gd name="connsiteX43" fmla="*/ 348006 w 5763198"/>
              <a:gd name="connsiteY43" fmla="*/ 6063412 h 6374064"/>
              <a:gd name="connsiteX44" fmla="*/ 0 w 5763198"/>
              <a:gd name="connsiteY44" fmla="*/ 3993976 h 6374064"/>
              <a:gd name="connsiteX45" fmla="*/ 887775 w 5763198"/>
              <a:gd name="connsiteY45" fmla="*/ 1034018 h 6374064"/>
              <a:gd name="connsiteX46" fmla="*/ 3554490 w 5763198"/>
              <a:gd name="connsiteY46" fmla="*/ 0 h 63740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5763198" h="6374064">
                <a:moveTo>
                  <a:pt x="3554522" y="1277148"/>
                </a:moveTo>
                <a:lnTo>
                  <a:pt x="4965198" y="2685220"/>
                </a:lnTo>
                <a:lnTo>
                  <a:pt x="4638987" y="3010816"/>
                </a:lnTo>
                <a:lnTo>
                  <a:pt x="3785164" y="2158571"/>
                </a:lnTo>
                <a:lnTo>
                  <a:pt x="3785164" y="3610576"/>
                </a:lnTo>
                <a:lnTo>
                  <a:pt x="4797652" y="3610576"/>
                </a:lnTo>
                <a:lnTo>
                  <a:pt x="4797652" y="4071018"/>
                </a:lnTo>
                <a:lnTo>
                  <a:pt x="3785164" y="4071018"/>
                </a:lnTo>
                <a:lnTo>
                  <a:pt x="3785164" y="4427325"/>
                </a:lnTo>
                <a:lnTo>
                  <a:pt x="4797652" y="4427325"/>
                </a:lnTo>
                <a:lnTo>
                  <a:pt x="4797652" y="4887800"/>
                </a:lnTo>
                <a:lnTo>
                  <a:pt x="3785164" y="4887800"/>
                </a:lnTo>
                <a:lnTo>
                  <a:pt x="3785164" y="5244106"/>
                </a:lnTo>
                <a:lnTo>
                  <a:pt x="4797652" y="5244106"/>
                </a:lnTo>
                <a:lnTo>
                  <a:pt x="4797652" y="5704548"/>
                </a:lnTo>
                <a:lnTo>
                  <a:pt x="3785164" y="5704548"/>
                </a:lnTo>
                <a:lnTo>
                  <a:pt x="3785164" y="6374064"/>
                </a:lnTo>
                <a:lnTo>
                  <a:pt x="3323858" y="6374064"/>
                </a:lnTo>
                <a:lnTo>
                  <a:pt x="3323858" y="5704548"/>
                </a:lnTo>
                <a:lnTo>
                  <a:pt x="2311348" y="5704548"/>
                </a:lnTo>
                <a:lnTo>
                  <a:pt x="2311348" y="5244106"/>
                </a:lnTo>
                <a:lnTo>
                  <a:pt x="3323858" y="5244106"/>
                </a:lnTo>
                <a:lnTo>
                  <a:pt x="3323858" y="4887800"/>
                </a:lnTo>
                <a:lnTo>
                  <a:pt x="2311348" y="4887800"/>
                </a:lnTo>
                <a:lnTo>
                  <a:pt x="2311348" y="4427325"/>
                </a:lnTo>
                <a:lnTo>
                  <a:pt x="3323858" y="4427325"/>
                </a:lnTo>
                <a:lnTo>
                  <a:pt x="3323858" y="4071018"/>
                </a:lnTo>
                <a:lnTo>
                  <a:pt x="2311348" y="4071018"/>
                </a:lnTo>
                <a:lnTo>
                  <a:pt x="2311348" y="3610576"/>
                </a:lnTo>
                <a:lnTo>
                  <a:pt x="3323858" y="3610576"/>
                </a:lnTo>
                <a:lnTo>
                  <a:pt x="3323858" y="2158603"/>
                </a:lnTo>
                <a:lnTo>
                  <a:pt x="2470036" y="3010816"/>
                </a:lnTo>
                <a:lnTo>
                  <a:pt x="2143825" y="2685220"/>
                </a:lnTo>
                <a:close/>
                <a:moveTo>
                  <a:pt x="3554490" y="0"/>
                </a:moveTo>
                <a:cubicBezTo>
                  <a:pt x="4429874" y="0"/>
                  <a:pt x="5153422" y="195695"/>
                  <a:pt x="5714575" y="582998"/>
                </a:cubicBezTo>
                <a:lnTo>
                  <a:pt x="5763198" y="618804"/>
                </a:lnTo>
                <a:lnTo>
                  <a:pt x="5763198" y="1232611"/>
                </a:lnTo>
                <a:lnTo>
                  <a:pt x="5668108" y="1136723"/>
                </a:lnTo>
                <a:cubicBezTo>
                  <a:pt x="5160837" y="685819"/>
                  <a:pt x="4456297" y="460367"/>
                  <a:pt x="3554490" y="460367"/>
                </a:cubicBezTo>
                <a:cubicBezTo>
                  <a:pt x="1493207" y="460367"/>
                  <a:pt x="462581" y="1638240"/>
                  <a:pt x="462581" y="3993976"/>
                </a:cubicBezTo>
                <a:cubicBezTo>
                  <a:pt x="462581" y="4877377"/>
                  <a:pt x="607513" y="5595144"/>
                  <a:pt x="897378" y="6147274"/>
                </a:cubicBezTo>
                <a:lnTo>
                  <a:pt x="1033153" y="6374064"/>
                </a:lnTo>
                <a:lnTo>
                  <a:pt x="493028" y="6374064"/>
                </a:lnTo>
                <a:lnTo>
                  <a:pt x="348006" y="6063412"/>
                </a:lnTo>
                <a:cubicBezTo>
                  <a:pt x="116679" y="5494171"/>
                  <a:pt x="0" y="4802111"/>
                  <a:pt x="0" y="3993976"/>
                </a:cubicBezTo>
                <a:cubicBezTo>
                  <a:pt x="0" y="2700970"/>
                  <a:pt x="298698" y="1705096"/>
                  <a:pt x="887775" y="1034018"/>
                </a:cubicBezTo>
                <a:cubicBezTo>
                  <a:pt x="1490095" y="347903"/>
                  <a:pt x="2387300" y="0"/>
                  <a:pt x="3554490" y="0"/>
                </a:cubicBezTo>
                <a:close/>
              </a:path>
            </a:pathLst>
          </a:custGeom>
          <a:solidFill>
            <a:schemeClr val="accent1">
              <a:alpha val="25000"/>
            </a:schemeClr>
          </a:solidFill>
          <a:ln w="3001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0CE4FF-62C5-5C44-AE4A-3D38634FF8CF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3278743C-5E55-7D4C-9CFF-3A25EB7EE36F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04825" y="1371600"/>
            <a:ext cx="7419975" cy="4718050"/>
          </a:xfrm>
        </p:spPr>
        <p:txBody>
          <a:bodyPr vert="horz" anchor="ctr"/>
          <a:lstStyle>
            <a:lvl1pPr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his slide is for a divider, statement or takeaway.</a:t>
            </a:r>
          </a:p>
        </p:txBody>
      </p:sp>
    </p:spTree>
    <p:extLst>
      <p:ext uri="{BB962C8B-B14F-4D97-AF65-F5344CB8AC3E}">
        <p14:creationId xmlns:p14="http://schemas.microsoft.com/office/powerpoint/2010/main" val="246610987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Only + Content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1997839"/>
            <a:ext cx="12191999" cy="2862322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Title Only + Content layouts</a:t>
            </a:r>
          </a:p>
        </p:txBody>
      </p:sp>
    </p:spTree>
    <p:extLst>
      <p:ext uri="{BB962C8B-B14F-4D97-AF65-F5344CB8AC3E}">
        <p14:creationId xmlns:p14="http://schemas.microsoft.com/office/powerpoint/2010/main" val="93274526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45600550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824461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61107631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8869112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har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1"/>
            <a:ext cx="11184423" cy="545670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69F89A7-422D-6E43-B01B-1C31D8C92DF7}"/>
              </a:ext>
            </a:extLst>
          </p:cNvPr>
          <p:cNvCxnSpPr>
            <a:cxnSpLocks/>
          </p:cNvCxnSpPr>
          <p:nvPr/>
        </p:nvCxnSpPr>
        <p:spPr>
          <a:xfrm>
            <a:off x="6096000" y="1245991"/>
            <a:ext cx="0" cy="50372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B854DB1-6F60-374F-85D1-2078301A4756}"/>
              </a:ext>
            </a:extLst>
          </p:cNvPr>
          <p:cNvCxnSpPr>
            <a:cxnSpLocks/>
          </p:cNvCxnSpPr>
          <p:nvPr/>
        </p:nvCxnSpPr>
        <p:spPr>
          <a:xfrm>
            <a:off x="514662" y="3672114"/>
            <a:ext cx="111626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hart Placeholder 5">
            <a:extLst>
              <a:ext uri="{FF2B5EF4-FFF2-40B4-BE49-F238E27FC236}">
                <a16:creationId xmlns:a16="http://schemas.microsoft.com/office/drawing/2014/main" id="{2EECEB55-4129-C142-B378-69A5542D932F}"/>
              </a:ext>
            </a:extLst>
          </p:cNvPr>
          <p:cNvSpPr>
            <a:spLocks noGrp="1"/>
          </p:cNvSpPr>
          <p:nvPr>
            <p:ph type="chart" sz="quarter" idx="13"/>
          </p:nvPr>
        </p:nvSpPr>
        <p:spPr>
          <a:xfrm>
            <a:off x="1965882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16" name="Text Placeholder 15">
            <a:extLst>
              <a:ext uri="{FF2B5EF4-FFF2-40B4-BE49-F238E27FC236}">
                <a16:creationId xmlns:a16="http://schemas.microsoft.com/office/drawing/2014/main" id="{88A2C02F-6913-2B43-A60C-B20E91E2B847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512063" y="1246188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19" name="Chart Placeholder 5">
            <a:extLst>
              <a:ext uri="{FF2B5EF4-FFF2-40B4-BE49-F238E27FC236}">
                <a16:creationId xmlns:a16="http://schemas.microsoft.com/office/drawing/2014/main" id="{FBED512D-1416-8241-B26E-2C62760A3337}"/>
              </a:ext>
            </a:extLst>
          </p:cNvPr>
          <p:cNvSpPr>
            <a:spLocks noGrp="1"/>
          </p:cNvSpPr>
          <p:nvPr>
            <p:ph type="chart" sz="quarter" idx="15"/>
          </p:nvPr>
        </p:nvSpPr>
        <p:spPr>
          <a:xfrm>
            <a:off x="7900534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0" name="Text Placeholder 15">
            <a:extLst>
              <a:ext uri="{FF2B5EF4-FFF2-40B4-BE49-F238E27FC236}">
                <a16:creationId xmlns:a16="http://schemas.microsoft.com/office/drawing/2014/main" id="{AA19A0ED-BA56-C641-9FF8-E82F9484CB2A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6446715" y="1246188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1" name="Chart Placeholder 5">
            <a:extLst>
              <a:ext uri="{FF2B5EF4-FFF2-40B4-BE49-F238E27FC236}">
                <a16:creationId xmlns:a16="http://schemas.microsoft.com/office/drawing/2014/main" id="{411CA850-8503-9541-BEA4-672B310F90A7}"/>
              </a:ext>
            </a:extLst>
          </p:cNvPr>
          <p:cNvSpPr>
            <a:spLocks noGrp="1"/>
          </p:cNvSpPr>
          <p:nvPr>
            <p:ph type="chart" sz="quarter" idx="17"/>
          </p:nvPr>
        </p:nvSpPr>
        <p:spPr>
          <a:xfrm>
            <a:off x="1965882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2" name="Text Placeholder 15">
            <a:extLst>
              <a:ext uri="{FF2B5EF4-FFF2-40B4-BE49-F238E27FC236}">
                <a16:creationId xmlns:a16="http://schemas.microsoft.com/office/drawing/2014/main" id="{9DAD6729-5DDE-B249-8CA6-D07213AF42CF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2063" y="3997016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3" name="Chart Placeholder 5">
            <a:extLst>
              <a:ext uri="{FF2B5EF4-FFF2-40B4-BE49-F238E27FC236}">
                <a16:creationId xmlns:a16="http://schemas.microsoft.com/office/drawing/2014/main" id="{CE4A6E97-2092-E146-9440-ACDFA4D9DC57}"/>
              </a:ext>
            </a:extLst>
          </p:cNvPr>
          <p:cNvSpPr>
            <a:spLocks noGrp="1"/>
          </p:cNvSpPr>
          <p:nvPr>
            <p:ph type="chart" sz="quarter" idx="19"/>
          </p:nvPr>
        </p:nvSpPr>
        <p:spPr>
          <a:xfrm>
            <a:off x="7900534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4" name="Text Placeholder 15">
            <a:extLst>
              <a:ext uri="{FF2B5EF4-FFF2-40B4-BE49-F238E27FC236}">
                <a16:creationId xmlns:a16="http://schemas.microsoft.com/office/drawing/2014/main" id="{D8573F34-F275-3047-800C-0AE4F271C6B8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6446715" y="3997016"/>
            <a:ext cx="1103106" cy="1073920"/>
          </a:xfrm>
        </p:spPr>
        <p:txBody>
          <a:bodyPr/>
          <a:lstStyle>
            <a:lvl1pPr>
              <a:defRPr b="1"/>
            </a:lvl1pPr>
          </a:lstStyle>
          <a:p>
            <a:pPr lvl="0"/>
            <a:r>
              <a:rPr lang="en-US" dirty="0"/>
              <a:t>Chart title</a:t>
            </a:r>
          </a:p>
        </p:txBody>
      </p:sp>
    </p:spTree>
    <p:extLst>
      <p:ext uri="{BB962C8B-B14F-4D97-AF65-F5344CB8AC3E}">
        <p14:creationId xmlns:p14="http://schemas.microsoft.com/office/powerpoint/2010/main" val="54754463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1/2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708A9BD9-B4C1-F761-F29D-1A29B1DDDC1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1" name="Text Placeholder 5">
            <a:extLst>
              <a:ext uri="{FF2B5EF4-FFF2-40B4-BE49-F238E27FC236}">
                <a16:creationId xmlns:a16="http://schemas.microsoft.com/office/drawing/2014/main" id="{31B503BD-4158-2C40-9E38-005D18DF3C4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41153834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/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</p:spTree>
    <p:extLst>
      <p:ext uri="{BB962C8B-B14F-4D97-AF65-F5344CB8AC3E}">
        <p14:creationId xmlns:p14="http://schemas.microsoft.com/office/powerpoint/2010/main" val="108732813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BF1AE-67E6-D446-9A89-2B8C3A9901F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8E978-662F-C447-A394-0BFDCC3348A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7" name="Footnote Placeholder">
            <a:extLst>
              <a:ext uri="{FF2B5EF4-FFF2-40B4-BE49-F238E27FC236}">
                <a16:creationId xmlns:a16="http://schemas.microsoft.com/office/drawing/2014/main" id="{900719BC-444F-1F41-A58F-CF38F8649706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</p:spTree>
    <p:extLst>
      <p:ext uri="{BB962C8B-B14F-4D97-AF65-F5344CB8AC3E}">
        <p14:creationId xmlns:p14="http://schemas.microsoft.com/office/powerpoint/2010/main" val="228144216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448726516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41281824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8452869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04037201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Four Charts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1"/>
            <a:ext cx="11184423" cy="545670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69F89A7-422D-6E43-B01B-1C31D8C92DF7}"/>
              </a:ext>
            </a:extLst>
          </p:cNvPr>
          <p:cNvCxnSpPr>
            <a:cxnSpLocks/>
          </p:cNvCxnSpPr>
          <p:nvPr/>
        </p:nvCxnSpPr>
        <p:spPr>
          <a:xfrm>
            <a:off x="6096000" y="1245991"/>
            <a:ext cx="0" cy="503722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B854DB1-6F60-374F-85D1-2078301A4756}"/>
              </a:ext>
            </a:extLst>
          </p:cNvPr>
          <p:cNvCxnSpPr>
            <a:cxnSpLocks/>
          </p:cNvCxnSpPr>
          <p:nvPr/>
        </p:nvCxnSpPr>
        <p:spPr>
          <a:xfrm>
            <a:off x="514662" y="3672114"/>
            <a:ext cx="1116267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hart Placeholder 5">
            <a:extLst>
              <a:ext uri="{FF2B5EF4-FFF2-40B4-BE49-F238E27FC236}">
                <a16:creationId xmlns:a16="http://schemas.microsoft.com/office/drawing/2014/main" id="{2EECEB55-4129-C142-B378-69A5542D932F}"/>
              </a:ext>
            </a:extLst>
          </p:cNvPr>
          <p:cNvSpPr>
            <a:spLocks noGrp="1"/>
          </p:cNvSpPr>
          <p:nvPr>
            <p:ph type="chart" sz="quarter" idx="13"/>
          </p:nvPr>
        </p:nvSpPr>
        <p:spPr>
          <a:xfrm>
            <a:off x="1965882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16" name="Text Placeholder 15">
            <a:extLst>
              <a:ext uri="{FF2B5EF4-FFF2-40B4-BE49-F238E27FC236}">
                <a16:creationId xmlns:a16="http://schemas.microsoft.com/office/drawing/2014/main" id="{88A2C02F-6913-2B43-A60C-B20E91E2B847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512063" y="1246188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19" name="Chart Placeholder 5">
            <a:extLst>
              <a:ext uri="{FF2B5EF4-FFF2-40B4-BE49-F238E27FC236}">
                <a16:creationId xmlns:a16="http://schemas.microsoft.com/office/drawing/2014/main" id="{FBED512D-1416-8241-B26E-2C62760A3337}"/>
              </a:ext>
            </a:extLst>
          </p:cNvPr>
          <p:cNvSpPr>
            <a:spLocks noGrp="1"/>
          </p:cNvSpPr>
          <p:nvPr>
            <p:ph type="chart" sz="quarter" idx="15"/>
          </p:nvPr>
        </p:nvSpPr>
        <p:spPr>
          <a:xfrm>
            <a:off x="7900534" y="1245991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0" name="Text Placeholder 15">
            <a:extLst>
              <a:ext uri="{FF2B5EF4-FFF2-40B4-BE49-F238E27FC236}">
                <a16:creationId xmlns:a16="http://schemas.microsoft.com/office/drawing/2014/main" id="{AA19A0ED-BA56-C641-9FF8-E82F9484CB2A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6446715" y="1246188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1" name="Chart Placeholder 5">
            <a:extLst>
              <a:ext uri="{FF2B5EF4-FFF2-40B4-BE49-F238E27FC236}">
                <a16:creationId xmlns:a16="http://schemas.microsoft.com/office/drawing/2014/main" id="{411CA850-8503-9541-BEA4-672B310F90A7}"/>
              </a:ext>
            </a:extLst>
          </p:cNvPr>
          <p:cNvSpPr>
            <a:spLocks noGrp="1"/>
          </p:cNvSpPr>
          <p:nvPr>
            <p:ph type="chart" sz="quarter" idx="17"/>
          </p:nvPr>
        </p:nvSpPr>
        <p:spPr>
          <a:xfrm>
            <a:off x="1965882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2" name="Text Placeholder 15">
            <a:extLst>
              <a:ext uri="{FF2B5EF4-FFF2-40B4-BE49-F238E27FC236}">
                <a16:creationId xmlns:a16="http://schemas.microsoft.com/office/drawing/2014/main" id="{9DAD6729-5DDE-B249-8CA6-D07213AF42CF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2063" y="3997016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  <p:sp>
        <p:nvSpPr>
          <p:cNvPr id="23" name="Chart Placeholder 5">
            <a:extLst>
              <a:ext uri="{FF2B5EF4-FFF2-40B4-BE49-F238E27FC236}">
                <a16:creationId xmlns:a16="http://schemas.microsoft.com/office/drawing/2014/main" id="{CE4A6E97-2092-E146-9440-ACDFA4D9DC57}"/>
              </a:ext>
            </a:extLst>
          </p:cNvPr>
          <p:cNvSpPr>
            <a:spLocks noGrp="1"/>
          </p:cNvSpPr>
          <p:nvPr>
            <p:ph type="chart" sz="quarter" idx="19"/>
          </p:nvPr>
        </p:nvSpPr>
        <p:spPr>
          <a:xfrm>
            <a:off x="7900534" y="3996819"/>
            <a:ext cx="3772813" cy="2286388"/>
          </a:xfrm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chart</a:t>
            </a:r>
          </a:p>
        </p:txBody>
      </p:sp>
      <p:sp>
        <p:nvSpPr>
          <p:cNvPr id="24" name="Text Placeholder 15">
            <a:extLst>
              <a:ext uri="{FF2B5EF4-FFF2-40B4-BE49-F238E27FC236}">
                <a16:creationId xmlns:a16="http://schemas.microsoft.com/office/drawing/2014/main" id="{D8573F34-F275-3047-800C-0AE4F271C6B8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6446715" y="3997016"/>
            <a:ext cx="1103106" cy="1073920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hart title</a:t>
            </a:r>
          </a:p>
        </p:txBody>
      </p:sp>
    </p:spTree>
    <p:extLst>
      <p:ext uri="{BB962C8B-B14F-4D97-AF65-F5344CB8AC3E}">
        <p14:creationId xmlns:p14="http://schemas.microsoft.com/office/powerpoint/2010/main" val="201448618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. This layout accommodates a title that extends downward to a 2nd line.</a:t>
            </a:r>
          </a:p>
        </p:txBody>
      </p:sp>
    </p:spTree>
    <p:extLst>
      <p:ext uri="{BB962C8B-B14F-4D97-AF65-F5344CB8AC3E}">
        <p14:creationId xmlns:p14="http://schemas.microsoft.com/office/powerpoint/2010/main" val="4240687729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8E978-662F-C447-A394-0BFDCC3348A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BF1AE-67E6-D446-9A89-2B8C3A9901F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note Placeholder">
            <a:extLst>
              <a:ext uri="{FF2B5EF4-FFF2-40B4-BE49-F238E27FC236}">
                <a16:creationId xmlns:a16="http://schemas.microsoft.com/office/drawing/2014/main" id="{900719BC-444F-1F41-A58F-CF38F8649706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</p:spTree>
    <p:extLst>
      <p:ext uri="{BB962C8B-B14F-4D97-AF65-F5344CB8AC3E}">
        <p14:creationId xmlns:p14="http://schemas.microsoft.com/office/powerpoint/2010/main" val="284967087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Title Eyebrow Subtitl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1997839"/>
            <a:ext cx="12191999" cy="2862322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Title and Subtitle-Above layouts</a:t>
            </a:r>
          </a:p>
        </p:txBody>
      </p:sp>
    </p:spTree>
    <p:extLst>
      <p:ext uri="{BB962C8B-B14F-4D97-AF65-F5344CB8AC3E}">
        <p14:creationId xmlns:p14="http://schemas.microsoft.com/office/powerpoint/2010/main" val="724490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  <a:latin typeface="+mn-lt"/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104408995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6C7144E-2BC5-BB49-A627-9076B48806A8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068709224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95373603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ubtitle-A + Content Half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A256062-B5BB-6048-9E24-6C230ACEACFF}"/>
              </a:ext>
            </a:extLst>
          </p:cNvPr>
          <p:cNvSpPr/>
          <p:nvPr/>
        </p:nvSpPr>
        <p:spPr>
          <a:xfrm>
            <a:off x="6096001" y="0"/>
            <a:ext cx="60960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riangle 12">
            <a:extLst>
              <a:ext uri="{FF2B5EF4-FFF2-40B4-BE49-F238E27FC236}">
                <a16:creationId xmlns:a16="http://schemas.microsoft.com/office/drawing/2014/main" id="{CD4D23E9-F985-964A-8260-25166ABD836C}"/>
              </a:ext>
            </a:extLst>
          </p:cNvPr>
          <p:cNvSpPr/>
          <p:nvPr/>
        </p:nvSpPr>
        <p:spPr>
          <a:xfrm rot="5400000">
            <a:off x="5899286" y="3271798"/>
            <a:ext cx="685800" cy="314404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5143286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815787"/>
            <a:ext cx="5126736" cy="555813"/>
          </a:xfrm>
        </p:spPr>
        <p:txBody>
          <a:bodyPr vert="horz"/>
          <a:lstStyle/>
          <a:p>
            <a:r>
              <a:rPr lang="en-US" dirty="0"/>
              <a:t>Slide title; short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421340"/>
            <a:ext cx="51267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short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4" y="1698625"/>
            <a:ext cx="5126736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77056798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52">
          <p15:clr>
            <a:srgbClr val="FBAE40"/>
          </p15:clr>
        </p15:guide>
        <p15:guide id="2" pos="4272">
          <p15:clr>
            <a:srgbClr val="FBAE40"/>
          </p15:clr>
        </p15:guide>
      </p15:sldGuideLst>
    </p:ext>
  </p:extLs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96555704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F05DDA7-2CBD-E44C-A62E-E1C57509DCA3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164661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60196467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itle Only Light Blue">
    <p:bg>
      <p:bgPr>
        <a:solidFill>
          <a:srgbClr val="F0F7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416075803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Content on Blu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-8965" y="0"/>
            <a:ext cx="4382814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815786"/>
            <a:ext cx="3412236" cy="1429677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hort slide title; Arial 32pt bold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ubtitle</a:t>
            </a:r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FA4A34C6-AA67-B74C-9387-5C2077CE6A33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0001759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Content on Blu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4381500" y="0"/>
            <a:ext cx="78105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815786"/>
            <a:ext cx="3412236" cy="1429677"/>
          </a:xfrm>
        </p:spPr>
        <p:txBody>
          <a:bodyPr vert="horz"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Short slide title; Arial 32pt bold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ubtitle</a:t>
            </a:r>
          </a:p>
        </p:txBody>
      </p:sp>
      <p:sp>
        <p:nvSpPr>
          <p:cNvPr id="14" name="Text Placeholder 19">
            <a:extLst>
              <a:ext uri="{FF2B5EF4-FFF2-40B4-BE49-F238E27FC236}">
                <a16:creationId xmlns:a16="http://schemas.microsoft.com/office/drawing/2014/main" id="{063F2128-9DD7-7445-8E1E-1AA47BED6A5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5" name="Content Placeholder 2">
            <a:extLst>
              <a:ext uri="{FF2B5EF4-FFF2-40B4-BE49-F238E27FC236}">
                <a16:creationId xmlns:a16="http://schemas.microsoft.com/office/drawing/2014/main" id="{05BA47CF-4C75-114D-925E-3DEE36B0B108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9794411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F29F3FD6-A58A-E748-A11A-7D0F672AD0A7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None/>
              <a:tabLst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202618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Im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0" y="0"/>
            <a:ext cx="12192000" cy="6858000"/>
          </a:xfrm>
          <a:noFill/>
        </p:spPr>
        <p:txBody>
          <a:bodyPr/>
          <a:lstStyle>
            <a:lvl1pPr algn="l">
              <a:defRPr sz="1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2304931428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wo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4F286C39-0E82-734F-AB13-0063DC613DC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90386682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hree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6474099B-156D-7348-B7A4-5FB85DB30944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1267125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Four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04B53DC-1086-544D-9442-160B5564CE8C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99591784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A + Title Only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4E3BD865-48DE-664B-B59C-69BE9486EDEB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476695679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Title and Subtitl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1997839"/>
            <a:ext cx="12191999" cy="2862322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Title and Subtitle-Below layouts</a:t>
            </a:r>
          </a:p>
        </p:txBody>
      </p:sp>
    </p:spTree>
    <p:extLst>
      <p:ext uri="{BB962C8B-B14F-4D97-AF65-F5344CB8AC3E}">
        <p14:creationId xmlns:p14="http://schemas.microsoft.com/office/powerpoint/2010/main" val="3482318003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39313C93-2B4C-9844-9284-03EC104B15B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12063" y="457201"/>
            <a:ext cx="11184423" cy="557784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6C7144E-2BC5-BB49-A627-9076B48806A8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56622315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2342699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ubtitle-B + Content Half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A256062-B5BB-6048-9E24-6C230ACEACFF}"/>
              </a:ext>
            </a:extLst>
          </p:cNvPr>
          <p:cNvSpPr/>
          <p:nvPr/>
        </p:nvSpPr>
        <p:spPr>
          <a:xfrm>
            <a:off x="6096001" y="0"/>
            <a:ext cx="60960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riangle 12">
            <a:extLst>
              <a:ext uri="{FF2B5EF4-FFF2-40B4-BE49-F238E27FC236}">
                <a16:creationId xmlns:a16="http://schemas.microsoft.com/office/drawing/2014/main" id="{CD4D23E9-F985-964A-8260-25166ABD836C}"/>
              </a:ext>
            </a:extLst>
          </p:cNvPr>
          <p:cNvSpPr/>
          <p:nvPr/>
        </p:nvSpPr>
        <p:spPr>
          <a:xfrm rot="5400000">
            <a:off x="5899286" y="3271798"/>
            <a:ext cx="685800" cy="314404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5143286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0"/>
            <a:ext cx="5126736" cy="555813"/>
          </a:xfrm>
        </p:spPr>
        <p:txBody>
          <a:bodyPr vert="horz"/>
          <a:lstStyle/>
          <a:p>
            <a:r>
              <a:rPr lang="en-US" dirty="0"/>
              <a:t>Slide title; short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D75F0135-B47D-BE40-8017-A3CF8C838B5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1051560"/>
            <a:ext cx="51267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short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4" y="1698625"/>
            <a:ext cx="5126736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78176696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552">
          <p15:clr>
            <a:srgbClr val="FBAE40"/>
          </p15:clr>
        </p15:guide>
        <p15:guide id="2" pos="4272">
          <p15:clr>
            <a:srgbClr val="FBAE40"/>
          </p15:clr>
        </p15:guide>
      </p15:sldGuideLst>
    </p:ext>
  </p:extLst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03430062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Fou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F05DDA7-2CBD-E44C-A62E-E1C57509DCA3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/>
            </a:lvl1pPr>
            <a:lvl2pPr>
              <a:defRPr sz="1400"/>
            </a:lvl2pPr>
            <a:lvl3pPr>
              <a:defRPr sz="1400"/>
            </a:lvl3pPr>
            <a:lvl4pPr>
              <a:defRPr sz="1400"/>
            </a:lvl4pPr>
            <a:lvl5pPr>
              <a:defRPr sz="1400"/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6757536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Blue 1/2 Im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E176EC07-7590-9014-296C-172578C5C04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E8ECE2AD-E262-0244-A779-32BC5B97C66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028989575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4105712868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itle Only Light Blue">
    <p:bg>
      <p:bgPr>
        <a:solidFill>
          <a:srgbClr val="F0F7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/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6119644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Content on Blu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0" y="0"/>
            <a:ext cx="4382814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3412236" cy="594360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hort slide title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lide subtitle</a:t>
            </a:r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FA4A34C6-AA67-B74C-9387-5C2077CE6A33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93274386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Content on Blu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F73B866B-F8DF-9344-BC29-1D15C9490777}"/>
              </a:ext>
            </a:extLst>
          </p:cNvPr>
          <p:cNvSpPr/>
          <p:nvPr/>
        </p:nvSpPr>
        <p:spPr>
          <a:xfrm>
            <a:off x="4381500" y="0"/>
            <a:ext cx="7810500" cy="685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4838700" y="6374651"/>
            <a:ext cx="3839134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3412236" cy="594360"/>
          </a:xfrm>
        </p:spPr>
        <p:txBody>
          <a:bodyPr vert="horz"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Short slide title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09B89761-8DE0-C74E-8229-82DCFB7CCA0E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3412236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hort slide subtitle</a:t>
            </a:r>
          </a:p>
        </p:txBody>
      </p:sp>
      <p:sp>
        <p:nvSpPr>
          <p:cNvPr id="14" name="Text Placeholder 19">
            <a:extLst>
              <a:ext uri="{FF2B5EF4-FFF2-40B4-BE49-F238E27FC236}">
                <a16:creationId xmlns:a16="http://schemas.microsoft.com/office/drawing/2014/main" id="{063F2128-9DD7-7445-8E1E-1AA47BED6A5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12064" y="2514590"/>
            <a:ext cx="3411537" cy="3590935"/>
          </a:xfrm>
        </p:spPr>
        <p:txBody>
          <a:bodyPr/>
          <a:lstStyle>
            <a:lvl1pPr>
              <a:defRPr>
                <a:solidFill>
                  <a:srgbClr val="272524"/>
                </a:solidFill>
              </a:defRPr>
            </a:lvl1pPr>
            <a:lvl2pPr>
              <a:defRPr>
                <a:solidFill>
                  <a:srgbClr val="272524"/>
                </a:solidFill>
              </a:defRPr>
            </a:lvl2pPr>
            <a:lvl3pPr>
              <a:defRPr>
                <a:solidFill>
                  <a:srgbClr val="272524"/>
                </a:solidFill>
              </a:defRPr>
            </a:lvl3pPr>
            <a:lvl4pPr>
              <a:defRPr>
                <a:solidFill>
                  <a:srgbClr val="272524"/>
                </a:solidFill>
              </a:defRPr>
            </a:lvl4pPr>
            <a:lvl5pPr>
              <a:defRPr>
                <a:solidFill>
                  <a:srgbClr val="272524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5" name="Content Placeholder 2">
            <a:extLst>
              <a:ext uri="{FF2B5EF4-FFF2-40B4-BE49-F238E27FC236}">
                <a16:creationId xmlns:a16="http://schemas.microsoft.com/office/drawing/2014/main" id="{05BA47CF-4C75-114D-925E-3DEE36B0B108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4838700" y="470636"/>
            <a:ext cx="6861175" cy="5634889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5624230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4" pos="3048">
          <p15:clr>
            <a:srgbClr val="FBAE40"/>
          </p15:clr>
        </p15:guide>
        <p15:guide id="5" orient="horz" pos="1576">
          <p15:clr>
            <a:srgbClr val="FBAE40"/>
          </p15:clr>
        </p15:guide>
      </p15:sldGuideLst>
    </p:ext>
  </p:extLst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755A1-263A-3047-860B-B811081C9CD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8D8092-2468-D648-A089-3B1A9527298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Footnote Placeholder">
            <a:extLst>
              <a:ext uri="{FF2B5EF4-FFF2-40B4-BE49-F238E27FC236}">
                <a16:creationId xmlns:a16="http://schemas.microsoft.com/office/drawing/2014/main" id="{5157959E-651B-B14F-BA5B-24DA1DB08587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F29F3FD6-A58A-E748-A11A-7D0F672AD0A7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368459007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wo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4F286C39-0E82-734F-AB13-0063DC613DC8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349019" y="1698625"/>
            <a:ext cx="5350855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7682772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696">
          <p15:clr>
            <a:srgbClr val="FBAE40"/>
          </p15:clr>
        </p15:guide>
        <p15:guide id="2" pos="3994">
          <p15:clr>
            <a:srgbClr val="FBAE40"/>
          </p15:clr>
        </p15:guide>
      </p15:sldGuideLst>
    </p:ext>
  </p:extLst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hree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6474099B-156D-7348-B7A4-5FB85DB30944}"/>
              </a:ext>
            </a:extLst>
          </p:cNvPr>
          <p:cNvSpPr>
            <a:spLocks noGrp="1"/>
          </p:cNvSpPr>
          <p:nvPr>
            <p:ph type="body" idx="14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3411513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390247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8278396" y="1698625"/>
            <a:ext cx="3421479" cy="4406900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20905601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72">
          <p15:clr>
            <a:srgbClr val="FBAE40"/>
          </p15:clr>
        </p15:guide>
        <p15:guide id="2" pos="2760">
          <p15:clr>
            <a:srgbClr val="FBAE40"/>
          </p15:clr>
        </p15:guide>
        <p15:guide id="3" pos="4920">
          <p15:clr>
            <a:srgbClr val="FBAE40"/>
          </p15:clr>
        </p15:guide>
        <p15:guide id="4" pos="5208">
          <p15:clr>
            <a:srgbClr val="FBAE40"/>
          </p15:clr>
        </p15:guide>
      </p15:sldGuideLst>
    </p:ext>
  </p:extLst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Four Content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2" name="Footnote Placeholder">
            <a:extLst>
              <a:ext uri="{FF2B5EF4-FFF2-40B4-BE49-F238E27FC236}">
                <a16:creationId xmlns:a16="http://schemas.microsoft.com/office/drawing/2014/main" id="{C2251F80-6554-A742-BC8C-483CBBFD6C91}"/>
              </a:ext>
            </a:extLst>
          </p:cNvPr>
          <p:cNvSpPr>
            <a:spLocks noGrp="1"/>
          </p:cNvSpPr>
          <p:nvPr>
            <p:ph type="body" sz="half" idx="1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3" name="Text Placeholder 2">
            <a:extLst>
              <a:ext uri="{FF2B5EF4-FFF2-40B4-BE49-F238E27FC236}">
                <a16:creationId xmlns:a16="http://schemas.microsoft.com/office/drawing/2014/main" id="{804B53DC-1086-544D-9442-160B5564CE8C}"/>
              </a:ext>
            </a:extLst>
          </p:cNvPr>
          <p:cNvSpPr>
            <a:spLocks noGrp="1"/>
          </p:cNvSpPr>
          <p:nvPr>
            <p:ph type="body" idx="15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512063" y="1698625"/>
            <a:ext cx="2512665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394922" y="1698625"/>
            <a:ext cx="2522219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Content Placeholder 3">
            <a:extLst>
              <a:ext uri="{FF2B5EF4-FFF2-40B4-BE49-F238E27FC236}">
                <a16:creationId xmlns:a16="http://schemas.microsoft.com/office/drawing/2014/main" id="{E0497FFB-B6FA-9D4E-B0A9-2B64230540B2}"/>
              </a:ext>
            </a:extLst>
          </p:cNvPr>
          <p:cNvSpPr>
            <a:spLocks noGrp="1"/>
          </p:cNvSpPr>
          <p:nvPr>
            <p:ph sz="half" idx="13" hasCustomPrompt="1"/>
          </p:nvPr>
        </p:nvSpPr>
        <p:spPr>
          <a:xfrm>
            <a:off x="6287335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5723D646-D659-4940-866D-282EF0E20D7A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9173716" y="1698625"/>
            <a:ext cx="2516188" cy="4406900"/>
          </a:xfrm>
        </p:spPr>
        <p:txBody>
          <a:bodyPr/>
          <a:lstStyle>
            <a:lvl1pPr>
              <a:defRPr sz="1400">
                <a:solidFill>
                  <a:schemeClr val="bg1"/>
                </a:solidFill>
              </a:defRPr>
            </a:lvl1pPr>
            <a:lvl2pPr>
              <a:defRPr sz="1400">
                <a:solidFill>
                  <a:schemeClr val="bg1"/>
                </a:solidFill>
              </a:defRPr>
            </a:lvl2pPr>
            <a:lvl3pPr>
              <a:defRPr sz="1400">
                <a:solidFill>
                  <a:schemeClr val="bg1"/>
                </a:solidFill>
              </a:defRPr>
            </a:lvl3pPr>
            <a:lvl4pPr>
              <a:defRPr sz="1400">
                <a:solidFill>
                  <a:schemeClr val="bg1"/>
                </a:solidFill>
              </a:defRPr>
            </a:lvl4pPr>
            <a:lvl5pPr>
              <a:defRPr sz="14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440128399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1896">
          <p15:clr>
            <a:srgbClr val="FBAE40"/>
          </p15:clr>
        </p15:guide>
        <p15:guide id="2" pos="2136">
          <p15:clr>
            <a:srgbClr val="FBAE40"/>
          </p15:clr>
        </p15:guide>
        <p15:guide id="3" pos="5545">
          <p15:clr>
            <a:srgbClr val="FBAE40"/>
          </p15:clr>
        </p15:guide>
        <p15:guide id="4" pos="5777">
          <p15:clr>
            <a:srgbClr val="FBAE40"/>
          </p15:clr>
        </p15:guide>
        <p15:guide id="5" pos="3720">
          <p15:clr>
            <a:srgbClr val="FBAE40"/>
          </p15:clr>
        </p15:guide>
        <p15:guide id="6" pos="3960">
          <p15:clr>
            <a:srgbClr val="FBAE40"/>
          </p15:clr>
        </p15:guide>
      </p15:sldGuideLst>
    </p:ext>
  </p:extLst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ubtitle-B + Title Only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57200"/>
            <a:ext cx="11184423" cy="555813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Slide title; Arial 32pt bold, sentence case (1 line)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4E3BD865-48DE-664B-B59C-69BE9486EDEB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105156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060887814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pecial layouts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2690337"/>
            <a:ext cx="12191999" cy="1477328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Special layouts</a:t>
            </a:r>
          </a:p>
        </p:txBody>
      </p:sp>
    </p:spTree>
    <p:extLst>
      <p:ext uri="{BB962C8B-B14F-4D97-AF65-F5344CB8AC3E}">
        <p14:creationId xmlns:p14="http://schemas.microsoft.com/office/powerpoint/2010/main" val="2590442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OD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phic 9">
            <a:extLst>
              <a:ext uri="{FF2B5EF4-FFF2-40B4-BE49-F238E27FC236}">
                <a16:creationId xmlns:a16="http://schemas.microsoft.com/office/drawing/2014/main" id="{C5E47407-2EC8-524C-85CD-E0BC1A1C8F1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739AB803-A532-384B-A53A-B6D4C36E506C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1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5" y="1371600"/>
            <a:ext cx="7419975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5A9A0FEB-2318-1E41-A04B-A702497639C9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096189643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ntro 2 Presente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FAEAF8F1-C826-6F47-BE7A-44717A37D861}"/>
              </a:ext>
            </a:extLst>
          </p:cNvPr>
          <p:cNvSpPr/>
          <p:nvPr/>
        </p:nvSpPr>
        <p:spPr>
          <a:xfrm>
            <a:off x="0" y="3666565"/>
            <a:ext cx="12192000" cy="3191436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11184422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21" name="Text Placeholder 20">
            <a:extLst>
              <a:ext uri="{FF2B5EF4-FFF2-40B4-BE49-F238E27FC236}">
                <a16:creationId xmlns:a16="http://schemas.microsoft.com/office/drawing/2014/main" id="{83520AB0-B15D-4644-8232-A1DA7A34C60E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2549141" y="1909334"/>
            <a:ext cx="2740035" cy="1102154"/>
          </a:xfrm>
        </p:spPr>
        <p:txBody>
          <a:bodyPr/>
          <a:lstStyle>
            <a:lvl1pPr>
              <a:defRPr sz="2400" b="1"/>
            </a:lvl1pPr>
            <a:lvl2pPr marL="0" indent="0">
              <a:buNone/>
              <a:defRPr sz="1400">
                <a:solidFill>
                  <a:schemeClr val="accent1"/>
                </a:solidFill>
              </a:defRPr>
            </a:lvl2pPr>
          </a:lstStyle>
          <a:p>
            <a:pPr lvl="0"/>
            <a:r>
              <a:rPr lang="en-US" dirty="0"/>
              <a:t>First </a:t>
            </a:r>
            <a:r>
              <a:rPr lang="en-US" dirty="0" err="1"/>
              <a:t>Lastname</a:t>
            </a:r>
            <a:endParaRPr lang="en-US" dirty="0"/>
          </a:p>
          <a:p>
            <a:pPr lvl="1"/>
            <a:r>
              <a:rPr lang="en-US" dirty="0"/>
              <a:t>Add title</a:t>
            </a:r>
          </a:p>
        </p:txBody>
      </p:sp>
      <p:sp>
        <p:nvSpPr>
          <p:cNvPr id="23" name="Text Placeholder 20">
            <a:extLst>
              <a:ext uri="{FF2B5EF4-FFF2-40B4-BE49-F238E27FC236}">
                <a16:creationId xmlns:a16="http://schemas.microsoft.com/office/drawing/2014/main" id="{A186D89A-9D30-6C4F-925D-4091D0F3D93A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8501706" y="1909334"/>
            <a:ext cx="2740035" cy="1102154"/>
          </a:xfrm>
        </p:spPr>
        <p:txBody>
          <a:bodyPr/>
          <a:lstStyle>
            <a:lvl1pPr>
              <a:defRPr sz="2400" b="1"/>
            </a:lvl1pPr>
            <a:lvl2pPr marL="0" indent="0">
              <a:buNone/>
              <a:defRPr sz="1400">
                <a:solidFill>
                  <a:schemeClr val="accent1"/>
                </a:solidFill>
              </a:defRPr>
            </a:lvl2pPr>
          </a:lstStyle>
          <a:p>
            <a:pPr lvl="0"/>
            <a:r>
              <a:rPr lang="en-US" dirty="0"/>
              <a:t>First </a:t>
            </a:r>
            <a:r>
              <a:rPr lang="en-US" dirty="0" err="1"/>
              <a:t>Lastname</a:t>
            </a:r>
            <a:endParaRPr lang="en-US" dirty="0"/>
          </a:p>
          <a:p>
            <a:pPr lvl="1"/>
            <a:r>
              <a:rPr lang="en-US" dirty="0"/>
              <a:t>Add title</a:t>
            </a:r>
          </a:p>
        </p:txBody>
      </p:sp>
      <p:sp>
        <p:nvSpPr>
          <p:cNvPr id="18" name="Picture Placeholder 17">
            <a:extLst>
              <a:ext uri="{FF2B5EF4-FFF2-40B4-BE49-F238E27FC236}">
                <a16:creationId xmlns:a16="http://schemas.microsoft.com/office/drawing/2014/main" id="{E68A2CBF-6F30-2D4C-BD65-7D6157EA8B3A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471702" y="1255958"/>
            <a:ext cx="1793168" cy="2014784"/>
          </a:xfrm>
          <a:custGeom>
            <a:avLst/>
            <a:gdLst>
              <a:gd name="connsiteX0" fmla="*/ 896584 w 1793168"/>
              <a:gd name="connsiteY0" fmla="*/ 0 h 2014784"/>
              <a:gd name="connsiteX1" fmla="*/ 1569239 w 1793168"/>
              <a:gd name="connsiteY1" fmla="*/ 261487 h 2014784"/>
              <a:gd name="connsiteX2" fmla="*/ 1793168 w 1793168"/>
              <a:gd name="connsiteY2" fmla="*/ 1007392 h 2014784"/>
              <a:gd name="connsiteX3" fmla="*/ 1569239 w 1793168"/>
              <a:gd name="connsiteY3" fmla="*/ 1753297 h 2014784"/>
              <a:gd name="connsiteX4" fmla="*/ 896584 w 1793168"/>
              <a:gd name="connsiteY4" fmla="*/ 2014784 h 2014784"/>
              <a:gd name="connsiteX5" fmla="*/ 223928 w 1793168"/>
              <a:gd name="connsiteY5" fmla="*/ 1753297 h 2014784"/>
              <a:gd name="connsiteX6" fmla="*/ 0 w 1793168"/>
              <a:gd name="connsiteY6" fmla="*/ 1007392 h 2014784"/>
              <a:gd name="connsiteX7" fmla="*/ 223928 w 1793168"/>
              <a:gd name="connsiteY7" fmla="*/ 261487 h 2014784"/>
              <a:gd name="connsiteX8" fmla="*/ 896584 w 1793168"/>
              <a:gd name="connsiteY8" fmla="*/ 0 h 20147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793168" h="2014784">
                <a:moveTo>
                  <a:pt x="896584" y="0"/>
                </a:moveTo>
                <a:cubicBezTo>
                  <a:pt x="1190802" y="0"/>
                  <a:pt x="1417125" y="87983"/>
                  <a:pt x="1569239" y="261487"/>
                </a:cubicBezTo>
                <a:cubicBezTo>
                  <a:pt x="1717872" y="430859"/>
                  <a:pt x="1793168" y="681837"/>
                  <a:pt x="1793168" y="1007392"/>
                </a:cubicBezTo>
                <a:cubicBezTo>
                  <a:pt x="1793168" y="1332946"/>
                  <a:pt x="1717799" y="1583925"/>
                  <a:pt x="1569239" y="1753297"/>
                </a:cubicBezTo>
                <a:cubicBezTo>
                  <a:pt x="1417052" y="1926800"/>
                  <a:pt x="1191093" y="2014784"/>
                  <a:pt x="896584" y="2014784"/>
                </a:cubicBezTo>
                <a:cubicBezTo>
                  <a:pt x="602075" y="2014784"/>
                  <a:pt x="376043" y="1926800"/>
                  <a:pt x="223928" y="1753297"/>
                </a:cubicBezTo>
                <a:cubicBezTo>
                  <a:pt x="75295" y="1583852"/>
                  <a:pt x="0" y="1332946"/>
                  <a:pt x="0" y="1007392"/>
                </a:cubicBezTo>
                <a:cubicBezTo>
                  <a:pt x="0" y="681837"/>
                  <a:pt x="75368" y="430859"/>
                  <a:pt x="223928" y="261487"/>
                </a:cubicBezTo>
                <a:cubicBezTo>
                  <a:pt x="376115" y="87983"/>
                  <a:pt x="602365" y="0"/>
                  <a:pt x="896584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</p:spPr>
        <p:txBody>
          <a:bodyPr wrap="square" lIns="0" tIns="457200" anchor="t">
            <a:noAutofit/>
          </a:bodyPr>
          <a:lstStyle>
            <a:lvl1pPr algn="ctr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Insert person’s photo</a:t>
            </a:r>
          </a:p>
        </p:txBody>
      </p:sp>
      <p:sp>
        <p:nvSpPr>
          <p:cNvPr id="19" name="Picture Placeholder 18">
            <a:extLst>
              <a:ext uri="{FF2B5EF4-FFF2-40B4-BE49-F238E27FC236}">
                <a16:creationId xmlns:a16="http://schemas.microsoft.com/office/drawing/2014/main" id="{1AA6058B-210D-DD48-8898-100F31B78D58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6447798" y="1255958"/>
            <a:ext cx="1793168" cy="2014784"/>
          </a:xfrm>
          <a:custGeom>
            <a:avLst/>
            <a:gdLst>
              <a:gd name="connsiteX0" fmla="*/ 896584 w 1793168"/>
              <a:gd name="connsiteY0" fmla="*/ 0 h 2014784"/>
              <a:gd name="connsiteX1" fmla="*/ 1569239 w 1793168"/>
              <a:gd name="connsiteY1" fmla="*/ 261487 h 2014784"/>
              <a:gd name="connsiteX2" fmla="*/ 1793168 w 1793168"/>
              <a:gd name="connsiteY2" fmla="*/ 1007392 h 2014784"/>
              <a:gd name="connsiteX3" fmla="*/ 1569239 w 1793168"/>
              <a:gd name="connsiteY3" fmla="*/ 1753297 h 2014784"/>
              <a:gd name="connsiteX4" fmla="*/ 896584 w 1793168"/>
              <a:gd name="connsiteY4" fmla="*/ 2014784 h 2014784"/>
              <a:gd name="connsiteX5" fmla="*/ 223928 w 1793168"/>
              <a:gd name="connsiteY5" fmla="*/ 1753297 h 2014784"/>
              <a:gd name="connsiteX6" fmla="*/ 0 w 1793168"/>
              <a:gd name="connsiteY6" fmla="*/ 1007392 h 2014784"/>
              <a:gd name="connsiteX7" fmla="*/ 223928 w 1793168"/>
              <a:gd name="connsiteY7" fmla="*/ 261487 h 2014784"/>
              <a:gd name="connsiteX8" fmla="*/ 896584 w 1793168"/>
              <a:gd name="connsiteY8" fmla="*/ 0 h 20147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793168" h="2014784">
                <a:moveTo>
                  <a:pt x="896584" y="0"/>
                </a:moveTo>
                <a:cubicBezTo>
                  <a:pt x="1190802" y="0"/>
                  <a:pt x="1417125" y="87983"/>
                  <a:pt x="1569239" y="261487"/>
                </a:cubicBezTo>
                <a:cubicBezTo>
                  <a:pt x="1717872" y="430859"/>
                  <a:pt x="1793168" y="681837"/>
                  <a:pt x="1793168" y="1007392"/>
                </a:cubicBezTo>
                <a:cubicBezTo>
                  <a:pt x="1793168" y="1332946"/>
                  <a:pt x="1717799" y="1583925"/>
                  <a:pt x="1569239" y="1753297"/>
                </a:cubicBezTo>
                <a:cubicBezTo>
                  <a:pt x="1417052" y="1926800"/>
                  <a:pt x="1191093" y="2014784"/>
                  <a:pt x="896584" y="2014784"/>
                </a:cubicBezTo>
                <a:cubicBezTo>
                  <a:pt x="602075" y="2014784"/>
                  <a:pt x="376043" y="1926800"/>
                  <a:pt x="223928" y="1753297"/>
                </a:cubicBezTo>
                <a:cubicBezTo>
                  <a:pt x="75295" y="1583852"/>
                  <a:pt x="0" y="1332946"/>
                  <a:pt x="0" y="1007392"/>
                </a:cubicBezTo>
                <a:cubicBezTo>
                  <a:pt x="0" y="681837"/>
                  <a:pt x="75368" y="430859"/>
                  <a:pt x="223928" y="261487"/>
                </a:cubicBezTo>
                <a:cubicBezTo>
                  <a:pt x="376115" y="87983"/>
                  <a:pt x="602365" y="0"/>
                  <a:pt x="896584" y="0"/>
                </a:cubicBezTo>
                <a:close/>
              </a:path>
            </a:pathLst>
          </a:custGeom>
          <a:solidFill>
            <a:schemeClr val="bg1">
              <a:lumMod val="95000"/>
            </a:schemeClr>
          </a:solidFill>
        </p:spPr>
        <p:txBody>
          <a:bodyPr wrap="square" tIns="457200" anchor="t">
            <a:noAutofit/>
          </a:bodyPr>
          <a:lstStyle>
            <a:lvl1pPr algn="ctr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Insert person’s photo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67ECDB41-474A-6442-AFDC-C46B467A134A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12763" y="4016187"/>
            <a:ext cx="11187112" cy="2089337"/>
          </a:xfrm>
        </p:spPr>
        <p:txBody>
          <a:bodyPr/>
          <a:lstStyle>
            <a:lvl1pPr marL="231775" indent="-231775">
              <a:spcBef>
                <a:spcPts val="1000"/>
              </a:spcBef>
              <a:buFont typeface="Arial" panose="020B0604020202020204" pitchFamily="34" charset="0"/>
              <a:buChar char="•"/>
              <a:tabLst/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add bullet points</a:t>
            </a:r>
          </a:p>
        </p:txBody>
      </p:sp>
    </p:spTree>
    <p:extLst>
      <p:ext uri="{BB962C8B-B14F-4D97-AF65-F5344CB8AC3E}">
        <p14:creationId xmlns:p14="http://schemas.microsoft.com/office/powerpoint/2010/main" val="270315027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tatem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3">
            <a:extLst>
              <a:ext uri="{FF2B5EF4-FFF2-40B4-BE49-F238E27FC236}">
                <a16:creationId xmlns:a16="http://schemas.microsoft.com/office/drawing/2014/main" id="{1B008058-B9DB-5E41-ADFA-69BE9568002B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0" y="0"/>
            <a:ext cx="12192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Bring placeholder to front. Drag picture to placeholder or click icon to add. Send placeholder to back. </a:t>
            </a:r>
            <a:br>
              <a:rPr lang="en-US" dirty="0"/>
            </a:br>
            <a:r>
              <a:rPr lang="en-US" dirty="0"/>
              <a:t>Note that the overlay sits on top of the slide; it will need to be pasted onto any new slide using this layout.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9" name="Footnote Placeholder">
            <a:extLst>
              <a:ext uri="{FF2B5EF4-FFF2-40B4-BE49-F238E27FC236}">
                <a16:creationId xmlns:a16="http://schemas.microsoft.com/office/drawing/2014/main" id="{180F6E86-A27A-FE40-B016-EB59307BF3CC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815787"/>
            <a:ext cx="6961399" cy="2519084"/>
          </a:xfrm>
        </p:spPr>
        <p:txBody>
          <a:bodyPr vert="horz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Large statement; Arial 32pt bold, sentence case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A96AF473-C2CF-6B47-84F7-6E0E41A10BCD}"/>
              </a:ext>
            </a:extLst>
          </p:cNvPr>
          <p:cNvSpPr>
            <a:spLocks noGrp="1"/>
          </p:cNvSpPr>
          <p:nvPr>
            <p:ph type="body" idx="12" hasCustomPrompt="1"/>
          </p:nvPr>
        </p:nvSpPr>
        <p:spPr>
          <a:xfrm>
            <a:off x="512064" y="421340"/>
            <a:ext cx="6961398" cy="295276"/>
          </a:xfrm>
        </p:spPr>
        <p:txBody>
          <a:bodyPr anchor="b"/>
          <a:lstStyle>
            <a:lvl1pPr marL="0" indent="0">
              <a:buNone/>
              <a:defRPr sz="2000" b="1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lide subtitle; Arial 20pt bold, sentence case (1 line)</a:t>
            </a:r>
          </a:p>
        </p:txBody>
      </p:sp>
    </p:spTree>
    <p:extLst>
      <p:ext uri="{BB962C8B-B14F-4D97-AF65-F5344CB8AC3E}">
        <p14:creationId xmlns:p14="http://schemas.microsoft.com/office/powerpoint/2010/main" val="3681421196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A64D66BA-EC5A-D945-99FE-DA74D720C612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0" y="0"/>
            <a:ext cx="12192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. Send placeholder to back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44F558-9BFF-B14B-8BE9-C6BBD3865858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BBCD08-FF08-374A-9A06-80B682368766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04CC9F91-EFE4-A54B-B9C5-6BBAE3D75CC2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0" y="1039089"/>
            <a:ext cx="5029200" cy="5029200"/>
          </a:xfrm>
          <a:solidFill>
            <a:schemeClr val="bg1"/>
          </a:solidFill>
        </p:spPr>
        <p:txBody>
          <a:bodyPr lIns="457200" tIns="1097280" rIns="457200"/>
          <a:lstStyle>
            <a:lvl1pPr>
              <a:defRPr sz="2400"/>
            </a:lvl1pPr>
            <a:lvl2pPr marL="0" indent="0">
              <a:buNone/>
              <a:defRPr>
                <a:solidFill>
                  <a:schemeClr val="accent1"/>
                </a:solidFill>
              </a:defRPr>
            </a:lvl2pPr>
          </a:lstStyle>
          <a:p>
            <a:pPr lvl="0"/>
            <a:r>
              <a:rPr lang="en-US" dirty="0"/>
              <a:t>Use this box to include quote. To activate sub-level formatting of attribution, place cursor at beginning of text/line and hit tab or shift tab. Do not modify size or placement of textbox.</a:t>
            </a:r>
          </a:p>
          <a:p>
            <a:pPr lvl="1"/>
            <a:r>
              <a:rPr lang="en-US" dirty="0"/>
              <a:t>Attribution name</a:t>
            </a:r>
          </a:p>
        </p:txBody>
      </p:sp>
    </p:spTree>
    <p:extLst>
      <p:ext uri="{BB962C8B-B14F-4D97-AF65-F5344CB8AC3E}">
        <p14:creationId xmlns:p14="http://schemas.microsoft.com/office/powerpoint/2010/main" val="2353574980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Large 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82389133-8F79-AF42-B505-8A150931C3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69DCA-0308-5E4B-8136-84AD580937A8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7" name="Freeform 16">
            <a:extLst>
              <a:ext uri="{FF2B5EF4-FFF2-40B4-BE49-F238E27FC236}">
                <a16:creationId xmlns:a16="http://schemas.microsoft.com/office/drawing/2014/main" id="{2A7B38F7-2661-CE4A-817E-73C2E2DCC1FB}"/>
              </a:ext>
            </a:extLst>
          </p:cNvPr>
          <p:cNvSpPr/>
          <p:nvPr/>
        </p:nvSpPr>
        <p:spPr>
          <a:xfrm>
            <a:off x="502080" y="1067823"/>
            <a:ext cx="553045" cy="409575"/>
          </a:xfrm>
          <a:custGeom>
            <a:avLst/>
            <a:gdLst/>
            <a:ahLst/>
            <a:cxnLst/>
            <a:rect l="l" t="t" r="r" b="b"/>
            <a:pathLst>
              <a:path w="553045" h="409575">
                <a:moveTo>
                  <a:pt x="530423" y="0"/>
                </a:moveTo>
                <a:lnTo>
                  <a:pt x="544711" y="26789"/>
                </a:lnTo>
                <a:cubicBezTo>
                  <a:pt x="508992" y="51792"/>
                  <a:pt x="481607" y="73819"/>
                  <a:pt x="462557" y="92869"/>
                </a:cubicBezTo>
                <a:cubicBezTo>
                  <a:pt x="428823" y="126603"/>
                  <a:pt x="411956" y="157956"/>
                  <a:pt x="411956" y="186928"/>
                </a:cubicBezTo>
                <a:cubicBezTo>
                  <a:pt x="411956" y="195262"/>
                  <a:pt x="414139" y="202009"/>
                  <a:pt x="418504" y="207169"/>
                </a:cubicBezTo>
                <a:cubicBezTo>
                  <a:pt x="422870" y="212328"/>
                  <a:pt x="428823" y="214908"/>
                  <a:pt x="436364" y="214908"/>
                </a:cubicBezTo>
                <a:cubicBezTo>
                  <a:pt x="451445" y="212923"/>
                  <a:pt x="461367" y="211931"/>
                  <a:pt x="466129" y="211931"/>
                </a:cubicBezTo>
                <a:cubicBezTo>
                  <a:pt x="491132" y="211931"/>
                  <a:pt x="511869" y="221059"/>
                  <a:pt x="528339" y="239316"/>
                </a:cubicBezTo>
                <a:cubicBezTo>
                  <a:pt x="544810" y="257572"/>
                  <a:pt x="553045" y="279995"/>
                  <a:pt x="553045" y="306586"/>
                </a:cubicBezTo>
                <a:cubicBezTo>
                  <a:pt x="553045" y="337542"/>
                  <a:pt x="543917" y="362446"/>
                  <a:pt x="525661" y="381298"/>
                </a:cubicBezTo>
                <a:cubicBezTo>
                  <a:pt x="507404" y="400149"/>
                  <a:pt x="482600" y="409575"/>
                  <a:pt x="451247" y="409575"/>
                </a:cubicBezTo>
                <a:cubicBezTo>
                  <a:pt x="415528" y="409575"/>
                  <a:pt x="386159" y="396379"/>
                  <a:pt x="363140" y="369987"/>
                </a:cubicBezTo>
                <a:cubicBezTo>
                  <a:pt x="340122" y="343594"/>
                  <a:pt x="328612" y="308372"/>
                  <a:pt x="328612" y="264319"/>
                </a:cubicBezTo>
                <a:cubicBezTo>
                  <a:pt x="328612" y="219869"/>
                  <a:pt x="344090" y="174030"/>
                  <a:pt x="375047" y="126801"/>
                </a:cubicBezTo>
                <a:cubicBezTo>
                  <a:pt x="406003" y="79573"/>
                  <a:pt x="457795" y="37306"/>
                  <a:pt x="530423" y="0"/>
                </a:cubicBezTo>
                <a:close/>
                <a:moveTo>
                  <a:pt x="201811" y="0"/>
                </a:moveTo>
                <a:lnTo>
                  <a:pt x="216098" y="26789"/>
                </a:lnTo>
                <a:cubicBezTo>
                  <a:pt x="177998" y="53776"/>
                  <a:pt x="149820" y="76398"/>
                  <a:pt x="131564" y="94655"/>
                </a:cubicBezTo>
                <a:cubicBezTo>
                  <a:pt x="99417" y="127595"/>
                  <a:pt x="83343" y="159147"/>
                  <a:pt x="83343" y="189309"/>
                </a:cubicBezTo>
                <a:cubicBezTo>
                  <a:pt x="83343" y="199628"/>
                  <a:pt x="86320" y="206375"/>
                  <a:pt x="92273" y="209550"/>
                </a:cubicBezTo>
                <a:cubicBezTo>
                  <a:pt x="98226" y="213122"/>
                  <a:pt x="103386" y="214908"/>
                  <a:pt x="107751" y="214908"/>
                </a:cubicBezTo>
                <a:cubicBezTo>
                  <a:pt x="122832" y="212923"/>
                  <a:pt x="132754" y="211931"/>
                  <a:pt x="137517" y="211931"/>
                </a:cubicBezTo>
                <a:cubicBezTo>
                  <a:pt x="162917" y="211931"/>
                  <a:pt x="183753" y="221158"/>
                  <a:pt x="200025" y="239613"/>
                </a:cubicBezTo>
                <a:cubicBezTo>
                  <a:pt x="216297" y="258068"/>
                  <a:pt x="224433" y="280392"/>
                  <a:pt x="224433" y="306586"/>
                </a:cubicBezTo>
                <a:cubicBezTo>
                  <a:pt x="224433" y="335955"/>
                  <a:pt x="215503" y="360462"/>
                  <a:pt x="197643" y="380107"/>
                </a:cubicBezTo>
                <a:cubicBezTo>
                  <a:pt x="179784" y="399752"/>
                  <a:pt x="155178" y="409575"/>
                  <a:pt x="123825" y="409575"/>
                </a:cubicBezTo>
                <a:cubicBezTo>
                  <a:pt x="86915" y="409575"/>
                  <a:pt x="57050" y="396379"/>
                  <a:pt x="34230" y="369987"/>
                </a:cubicBezTo>
                <a:cubicBezTo>
                  <a:pt x="11410" y="343594"/>
                  <a:pt x="0" y="308372"/>
                  <a:pt x="0" y="264319"/>
                </a:cubicBezTo>
                <a:cubicBezTo>
                  <a:pt x="0" y="222250"/>
                  <a:pt x="14585" y="177502"/>
                  <a:pt x="43755" y="130076"/>
                </a:cubicBezTo>
                <a:cubicBezTo>
                  <a:pt x="72925" y="82649"/>
                  <a:pt x="125611" y="39291"/>
                  <a:pt x="201811" y="0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  <a:effectLst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600" b="1" i="0" u="none" strike="noStrike" kern="1200" cap="none" spc="0" normalizeH="0" baseline="0" noProof="0" dirty="0">
              <a:ln>
                <a:noFill/>
              </a:ln>
              <a:solidFill>
                <a:srgbClr val="2E5FF4"/>
              </a:solidFill>
              <a:effectLst/>
              <a:uLnTx/>
              <a:uFillTx/>
              <a:latin typeface="Times" pitchFamily="2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3" y="405743"/>
            <a:ext cx="11184423" cy="307226"/>
          </a:xfrm>
        </p:spPr>
        <p:txBody>
          <a:bodyPr vert="horz" lIns="0" tIns="0" rIns="0" bIns="0" rtlCol="0" anchor="b">
            <a:noAutofit/>
          </a:bodyPr>
          <a:lstStyle>
            <a:lvl1pPr>
              <a:defRPr lang="en-US" sz="2000" b="1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1CEC1C1C-7C15-B146-89D1-4673F3599949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1312863" y="1175491"/>
            <a:ext cx="8928100" cy="3870325"/>
          </a:xfrm>
        </p:spPr>
        <p:txBody>
          <a:bodyPr/>
          <a:lstStyle>
            <a:lvl1pPr>
              <a:defRPr sz="2800" b="1"/>
            </a:lvl1pPr>
            <a:lvl2pPr marL="285750" indent="-285750">
              <a:buFont typeface="System Font Regular"/>
              <a:buChar char="–"/>
              <a:defRPr i="1"/>
            </a:lvl2pPr>
          </a:lstStyle>
          <a:p>
            <a:pPr lvl="0"/>
            <a:r>
              <a:rPr lang="en-US" dirty="0"/>
              <a:t>Use this box to include quote. To activate sub-level formatting of attribution, place cursor at beginning of text/line and hit tab or shift tab. Do not modify size or placement of textbox.</a:t>
            </a:r>
          </a:p>
          <a:p>
            <a:pPr lvl="1"/>
            <a:r>
              <a:rPr lang="en-US" dirty="0"/>
              <a:t>Attribution name</a:t>
            </a:r>
          </a:p>
        </p:txBody>
      </p:sp>
    </p:spTree>
    <p:extLst>
      <p:ext uri="{BB962C8B-B14F-4D97-AF65-F5344CB8AC3E}">
        <p14:creationId xmlns:p14="http://schemas.microsoft.com/office/powerpoint/2010/main" val="2887582308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 1/3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4381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847761" y="457201"/>
            <a:ext cx="6848725" cy="324444"/>
          </a:xfrm>
          <a:noFill/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846638" y="1011250"/>
            <a:ext cx="6853236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1921468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763">
          <p15:clr>
            <a:srgbClr val="FBAE40"/>
          </p15:clr>
        </p15:guide>
        <p15:guide id="2" pos="3053">
          <p15:clr>
            <a:srgbClr val="FBAE40"/>
          </p15:clr>
        </p15:guide>
      </p15:sldGuideLst>
    </p:ext>
  </p:extLst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+ 1/2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553200" y="457201"/>
            <a:ext cx="5143286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553200" y="1011250"/>
            <a:ext cx="5146674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95154021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  <p15:guide id="2" pos="4128">
          <p15:clr>
            <a:srgbClr val="FBAE40"/>
          </p15:clr>
        </p15:guide>
      </p15:sldGuideLst>
    </p:ext>
  </p:extLst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 2/3 Ima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0" y="0"/>
            <a:ext cx="7810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8284948" y="457201"/>
            <a:ext cx="3411538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8284948" y="1011250"/>
            <a:ext cx="3411538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1520197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5209">
          <p15:clr>
            <a:srgbClr val="FBAE40"/>
          </p15:clr>
        </p15:guide>
        <p15:guide id="2" pos="4924">
          <p15:clr>
            <a:srgbClr val="FBAE40"/>
          </p15:clr>
        </p15:guide>
      </p15:sldGuideLst>
    </p:ext>
  </p:extLst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1/3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 Placeholder 12">
            <a:extLst>
              <a:ext uri="{FF2B5EF4-FFF2-40B4-BE49-F238E27FC236}">
                <a16:creationId xmlns:a16="http://schemas.microsoft.com/office/drawing/2014/main" id="{D5400A53-EBCB-4C45-958D-0060F4E1C0AE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7810500" y="0"/>
            <a:ext cx="4381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1" name="Footnote Placeholder">
            <a:extLst>
              <a:ext uri="{FF2B5EF4-FFF2-40B4-BE49-F238E27FC236}">
                <a16:creationId xmlns:a16="http://schemas.microsoft.com/office/drawing/2014/main" id="{F20ACA8E-6072-8043-8EC3-B4E2FDB9B091}"/>
              </a:ext>
            </a:extLst>
          </p:cNvPr>
          <p:cNvSpPr>
            <a:spLocks noGrp="1"/>
          </p:cNvSpPr>
          <p:nvPr>
            <p:ph type="body" sz="half" idx="13" hasCustomPrompt="1"/>
          </p:nvPr>
        </p:nvSpPr>
        <p:spPr>
          <a:xfrm>
            <a:off x="512064" y="6374651"/>
            <a:ext cx="4434840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6829689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entence case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12064" y="1011250"/>
            <a:ext cx="6834188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7094122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4914">
          <p15:clr>
            <a:srgbClr val="FBAE40"/>
          </p15:clr>
        </p15:guide>
        <p15:guide id="2" pos="4623">
          <p15:clr>
            <a:srgbClr val="FBAE40"/>
          </p15:clr>
        </p15:guide>
      </p15:sldGuideLst>
    </p:ext>
  </p:extLst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+ 1/2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1" name="Footnote Placeholder">
            <a:extLst>
              <a:ext uri="{FF2B5EF4-FFF2-40B4-BE49-F238E27FC236}">
                <a16:creationId xmlns:a16="http://schemas.microsoft.com/office/drawing/2014/main" id="{F20ACA8E-6072-8043-8EC3-B4E2FDB9B091}"/>
              </a:ext>
            </a:extLst>
          </p:cNvPr>
          <p:cNvSpPr>
            <a:spLocks noGrp="1"/>
          </p:cNvSpPr>
          <p:nvPr>
            <p:ph type="body" sz="half" idx="13" hasCustomPrompt="1"/>
          </p:nvPr>
        </p:nvSpPr>
        <p:spPr>
          <a:xfrm>
            <a:off x="512064" y="6374651"/>
            <a:ext cx="5152597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5143286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Arial 20pt bold,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12064" y="1011250"/>
            <a:ext cx="5146674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6931954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>
          <p15:clr>
            <a:srgbClr val="FBAE40"/>
          </p15:clr>
        </p15:guide>
        <p15:guide id="2" pos="3552">
          <p15:clr>
            <a:srgbClr val="FBAE40"/>
          </p15:clr>
        </p15:guide>
      </p15:sldGuideLst>
    </p:ext>
  </p:extLst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+ 2/3 Ima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>
            <a:extLst>
              <a:ext uri="{FF2B5EF4-FFF2-40B4-BE49-F238E27FC236}">
                <a16:creationId xmlns:a16="http://schemas.microsoft.com/office/drawing/2014/main" id="{8B5636C5-BFB6-2342-91CC-8DC10C4A16D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4381500" y="0"/>
            <a:ext cx="78105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67A3A9BC-C48A-B640-9981-56B68FE2E241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F9A46-99FC-774E-98CA-CB47B58C9F81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11" name="Footnote Placeholder">
            <a:extLst>
              <a:ext uri="{FF2B5EF4-FFF2-40B4-BE49-F238E27FC236}">
                <a16:creationId xmlns:a16="http://schemas.microsoft.com/office/drawing/2014/main" id="{F20ACA8E-6072-8043-8EC3-B4E2FDB9B091}"/>
              </a:ext>
            </a:extLst>
          </p:cNvPr>
          <p:cNvSpPr>
            <a:spLocks noGrp="1"/>
          </p:cNvSpPr>
          <p:nvPr>
            <p:ph type="body" sz="half" idx="13" hasCustomPrompt="1"/>
          </p:nvPr>
        </p:nvSpPr>
        <p:spPr>
          <a:xfrm>
            <a:off x="512064" y="6374651"/>
            <a:ext cx="3411539" cy="245223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dirty="0"/>
              <a:t>Click to add a footnote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12064" y="457201"/>
            <a:ext cx="3411538" cy="324444"/>
          </a:xfrm>
        </p:spPr>
        <p:txBody>
          <a:bodyPr vert="horz"/>
          <a:lstStyle>
            <a:lvl1pPr>
              <a:defRPr sz="2000" b="1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Slide title; short (1 line)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12064" y="1011250"/>
            <a:ext cx="3411538" cy="5094275"/>
          </a:xfrm>
        </p:spPr>
        <p:txBody>
          <a:bodyPr/>
          <a:lstStyle/>
          <a:p>
            <a:pPr lvl="0"/>
            <a:r>
              <a:rPr lang="en-US" dirty="0"/>
              <a:t>Click to type text. To activate sub-level formatting, place cursor at beginning of text/line and hit tab or shift tab. Click icon for chart or table.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22905812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2467">
          <p15:clr>
            <a:srgbClr val="FBAE40"/>
          </p15:clr>
        </p15:guide>
        <p15:guide id="2" pos="2753">
          <p15:clr>
            <a:srgbClr val="FBAE40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1/2 Image OD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 hasCustomPrompt="1"/>
          </p:nvPr>
        </p:nvSpPr>
        <p:spPr>
          <a:xfrm>
            <a:off x="6096000" y="0"/>
            <a:ext cx="6096000" cy="6858000"/>
          </a:xfrm>
          <a:solidFill>
            <a:schemeClr val="bg1">
              <a:lumMod val="95000"/>
            </a:schemeClr>
          </a:solidFill>
        </p:spPr>
        <p:txBody>
          <a:bodyPr/>
          <a:lstStyle>
            <a:lvl1pPr algn="l">
              <a:defRPr sz="1200">
                <a:solidFill>
                  <a:srgbClr val="FF0000"/>
                </a:solidFill>
              </a:defRPr>
            </a:lvl1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12" name="Graphic 11">
            <a:extLst>
              <a:ext uri="{FF2B5EF4-FFF2-40B4-BE49-F238E27FC236}">
                <a16:creationId xmlns:a16="http://schemas.microsoft.com/office/drawing/2014/main" id="{708A9BD9-B4C1-F761-F29D-1A29B1DDDC1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504825" y="5582378"/>
            <a:ext cx="3505199" cy="73878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6" y="1920240"/>
            <a:ext cx="5131970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6" y="1371600"/>
            <a:ext cx="5131970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1" name="Text Placeholder 5">
            <a:extLst>
              <a:ext uri="{FF2B5EF4-FFF2-40B4-BE49-F238E27FC236}">
                <a16:creationId xmlns:a16="http://schemas.microsoft.com/office/drawing/2014/main" id="{31B503BD-4158-2C40-9E38-005D18DF3C4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5131971" cy="549249"/>
          </a:xfrm>
        </p:spPr>
        <p:txBody>
          <a:bodyPr/>
          <a:lstStyle>
            <a:lvl1pPr>
              <a:defRPr sz="3200">
                <a:solidFill>
                  <a:schemeClr val="accent1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4290881742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ack Pages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2">
            <a:extLst>
              <a:ext uri="{FF2B5EF4-FFF2-40B4-BE49-F238E27FC236}">
                <a16:creationId xmlns:a16="http://schemas.microsoft.com/office/drawing/2014/main" id="{9187A733-2828-FF4D-A1DC-7E7D7BF66120}"/>
              </a:ext>
            </a:extLst>
          </p:cNvPr>
          <p:cNvSpPr txBox="1"/>
          <p:nvPr/>
        </p:nvSpPr>
        <p:spPr>
          <a:xfrm>
            <a:off x="2" y="2690337"/>
            <a:ext cx="12191999" cy="1477328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9000" i="0" noProof="0" dirty="0">
                <a:solidFill>
                  <a:schemeClr val="tx2"/>
                </a:solidFill>
                <a:latin typeface="+mn-lt"/>
              </a:rPr>
              <a:t>End Page layouts</a:t>
            </a:r>
          </a:p>
        </p:txBody>
      </p:sp>
    </p:spTree>
    <p:extLst>
      <p:ext uri="{BB962C8B-B14F-4D97-AF65-F5344CB8AC3E}">
        <p14:creationId xmlns:p14="http://schemas.microsoft.com/office/powerpoint/2010/main" val="3873775343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ack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3EF54C89-1860-6542-AE68-06CDC85D9DE1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4481346" y="2628924"/>
            <a:ext cx="3229307" cy="160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4955981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ack Page Blu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3EF54C89-1860-6542-AE68-06CDC85D9DE1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4481346" y="2628924"/>
            <a:ext cx="3229307" cy="1600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972340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Warning">
    <p:bg>
      <p:bgPr>
        <a:blipFill dpi="0" rotWithShape="1">
          <a:blip r:embed="rId2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B7B9861-91E9-C742-B7A7-F218EA9C1F1A}"/>
              </a:ext>
            </a:extLst>
          </p:cNvPr>
          <p:cNvSpPr txBox="1"/>
          <p:nvPr/>
        </p:nvSpPr>
        <p:spPr>
          <a:xfrm>
            <a:off x="2" y="1651589"/>
            <a:ext cx="12191999" cy="3554819"/>
          </a:xfrm>
          <a:prstGeom prst="rect">
            <a:avLst/>
          </a:prstGeom>
          <a:noFill/>
        </p:spPr>
        <p:txBody>
          <a:bodyPr wrap="square" lIns="337500" rIns="337500" rtlCol="0" anchor="ctr" anchorCtr="0">
            <a:spAutoFit/>
          </a:bodyPr>
          <a:lstStyle/>
          <a:p>
            <a:pPr algn="ctr"/>
            <a:r>
              <a:rPr lang="en-CA" sz="7500" noProof="0" dirty="0">
                <a:solidFill>
                  <a:schemeClr val="tx2"/>
                </a:solidFill>
                <a:latin typeface="+mj-lt"/>
              </a:rPr>
              <a:t>Do not use any of the layouts that may appear after this one</a:t>
            </a:r>
          </a:p>
        </p:txBody>
      </p:sp>
    </p:spTree>
    <p:extLst>
      <p:ext uri="{BB962C8B-B14F-4D97-AF65-F5344CB8AC3E}">
        <p14:creationId xmlns:p14="http://schemas.microsoft.com/office/powerpoint/2010/main" val="675060350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052B9-0921-7912-8B5D-132D713E4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2F1C20-8A04-369A-4996-D0D934E381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6EAA83-BA60-B50D-5818-E2821386B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F3ED-A683-47B5-A581-7837EA1BE9F3}" type="datetimeFigureOut">
              <a:rPr lang="en-US" smtClean="0"/>
              <a:t>10/1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2E5E9B-7815-187B-1FC2-DE70DFCD68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D73382-CB1D-9107-77F7-B5DBA6C11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1A92B-32EF-44B7-ACEC-3418EC2184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281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Blue ODL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  <a:latin typeface="+mn-lt"/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5" y="1371600"/>
            <a:ext cx="7419975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576454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Image ODL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>
            <a:extLst>
              <a:ext uri="{FF2B5EF4-FFF2-40B4-BE49-F238E27FC236}">
                <a16:creationId xmlns:a16="http://schemas.microsoft.com/office/drawing/2014/main" id="{FA598385-0BD4-9F42-BC78-15B2A6F6CFA4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0" y="0"/>
            <a:ext cx="12192000" cy="6858000"/>
          </a:xfrm>
          <a:noFill/>
        </p:spPr>
        <p:txBody>
          <a:bodyPr/>
          <a:lstStyle>
            <a:lvl1pPr algn="l">
              <a:defRPr sz="1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Footer Placeholder 21">
            <a:extLst>
              <a:ext uri="{FF2B5EF4-FFF2-40B4-BE49-F238E27FC236}">
                <a16:creationId xmlns:a16="http://schemas.microsoft.com/office/drawing/2014/main" id="{7362EA3A-E7C3-1643-B148-AADECEDF26E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83797639-85AF-C0C6-DA9C-14EA9296F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04825" y="5580496"/>
            <a:ext cx="3514129" cy="74066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04825" y="1920240"/>
            <a:ext cx="7419975" cy="1508760"/>
          </a:xfrm>
        </p:spPr>
        <p:txBody>
          <a:bodyPr vert="horz" anchor="t"/>
          <a:lstStyle>
            <a:lvl1pPr algn="l">
              <a:defRPr sz="4800" b="1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add </a:t>
            </a:r>
            <a:br>
              <a:rPr lang="en-US" dirty="0"/>
            </a:br>
            <a:r>
              <a:rPr lang="en-US" dirty="0"/>
              <a:t>presentation 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4825" y="1371600"/>
            <a:ext cx="7419975" cy="530693"/>
          </a:xfrm>
        </p:spPr>
        <p:txBody>
          <a:bodyPr anchor="t"/>
          <a:lstStyle>
            <a:lvl1pPr marL="0" indent="0" algn="l">
              <a:buNone/>
              <a:defRPr sz="3200" b="1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add Org/Dept/Lab nam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1DA2E778-C602-5B40-8E0C-1BAE808E3694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504825" y="4389120"/>
            <a:ext cx="3505201" cy="457200"/>
          </a:xfrm>
        </p:spPr>
        <p:txBody>
          <a:bodyPr/>
          <a:lstStyle>
            <a:lvl1pPr>
              <a:defRPr sz="14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Month 00, 20XX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E99B368D-17E0-1440-9448-41A42D5E6456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04823" y="3566160"/>
            <a:ext cx="7419975" cy="549249"/>
          </a:xfrm>
        </p:spPr>
        <p:txBody>
          <a:bodyPr/>
          <a:lstStyle>
            <a:lvl1pPr>
              <a:defRPr sz="3200">
                <a:solidFill>
                  <a:schemeClr val="accent2"/>
                </a:solidFill>
              </a:defRPr>
            </a:lvl1pPr>
            <a:lvl2pPr marL="0" indent="0">
              <a:buNone/>
              <a:defRPr sz="1800">
                <a:solidFill>
                  <a:schemeClr val="accent2"/>
                </a:solidFill>
              </a:defRPr>
            </a:lvl2pPr>
            <a:lvl3pPr>
              <a:defRPr sz="1800">
                <a:solidFill>
                  <a:schemeClr val="accent2"/>
                </a:solidFill>
              </a:defRPr>
            </a:lvl3pPr>
            <a:lvl4pPr>
              <a:defRPr sz="1800">
                <a:solidFill>
                  <a:schemeClr val="accent2"/>
                </a:solidFill>
              </a:defRPr>
            </a:lvl4pPr>
            <a:lvl5pPr>
              <a:defRPr sz="1800"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add subtitle</a:t>
            </a:r>
          </a:p>
        </p:txBody>
      </p:sp>
    </p:spTree>
    <p:extLst>
      <p:ext uri="{BB962C8B-B14F-4D97-AF65-F5344CB8AC3E}">
        <p14:creationId xmlns:p14="http://schemas.microsoft.com/office/powerpoint/2010/main" val="3170470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6" Type="http://schemas.openxmlformats.org/officeDocument/2006/relationships/slideLayout" Target="../slideLayouts/slideLayout26.xml"/><Relationship Id="rId21" Type="http://schemas.openxmlformats.org/officeDocument/2006/relationships/slideLayout" Target="../slideLayouts/slideLayout21.xml"/><Relationship Id="rId42" Type="http://schemas.openxmlformats.org/officeDocument/2006/relationships/slideLayout" Target="../slideLayouts/slideLayout42.xml"/><Relationship Id="rId47" Type="http://schemas.openxmlformats.org/officeDocument/2006/relationships/slideLayout" Target="../slideLayouts/slideLayout47.xml"/><Relationship Id="rId63" Type="http://schemas.openxmlformats.org/officeDocument/2006/relationships/slideLayout" Target="../slideLayouts/slideLayout63.xml"/><Relationship Id="rId68" Type="http://schemas.openxmlformats.org/officeDocument/2006/relationships/slideLayout" Target="../slideLayouts/slideLayout68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9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45" Type="http://schemas.openxmlformats.org/officeDocument/2006/relationships/slideLayout" Target="../slideLayouts/slideLayout45.xml"/><Relationship Id="rId53" Type="http://schemas.openxmlformats.org/officeDocument/2006/relationships/slideLayout" Target="../slideLayouts/slideLayout53.xml"/><Relationship Id="rId58" Type="http://schemas.openxmlformats.org/officeDocument/2006/relationships/slideLayout" Target="../slideLayouts/slideLayout58.xml"/><Relationship Id="rId66" Type="http://schemas.openxmlformats.org/officeDocument/2006/relationships/slideLayout" Target="../slideLayouts/slideLayout66.xml"/><Relationship Id="rId74" Type="http://schemas.openxmlformats.org/officeDocument/2006/relationships/slideLayout" Target="../slideLayouts/slideLayout74.xml"/><Relationship Id="rId5" Type="http://schemas.openxmlformats.org/officeDocument/2006/relationships/slideLayout" Target="../slideLayouts/slideLayout5.xml"/><Relationship Id="rId61" Type="http://schemas.openxmlformats.org/officeDocument/2006/relationships/slideLayout" Target="../slideLayouts/slideLayout61.xml"/><Relationship Id="rId19" Type="http://schemas.openxmlformats.org/officeDocument/2006/relationships/slideLayout" Target="../slideLayouts/slideLayout1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43" Type="http://schemas.openxmlformats.org/officeDocument/2006/relationships/slideLayout" Target="../slideLayouts/slideLayout43.xml"/><Relationship Id="rId48" Type="http://schemas.openxmlformats.org/officeDocument/2006/relationships/slideLayout" Target="../slideLayouts/slideLayout48.xml"/><Relationship Id="rId56" Type="http://schemas.openxmlformats.org/officeDocument/2006/relationships/slideLayout" Target="../slideLayouts/slideLayout56.xml"/><Relationship Id="rId64" Type="http://schemas.openxmlformats.org/officeDocument/2006/relationships/slideLayout" Target="../slideLayouts/slideLayout64.xml"/><Relationship Id="rId69" Type="http://schemas.openxmlformats.org/officeDocument/2006/relationships/slideLayout" Target="../slideLayouts/slideLayout69.xml"/><Relationship Id="rId8" Type="http://schemas.openxmlformats.org/officeDocument/2006/relationships/slideLayout" Target="../slideLayouts/slideLayout8.xml"/><Relationship Id="rId51" Type="http://schemas.openxmlformats.org/officeDocument/2006/relationships/slideLayout" Target="../slideLayouts/slideLayout51.xml"/><Relationship Id="rId72" Type="http://schemas.openxmlformats.org/officeDocument/2006/relationships/slideLayout" Target="../slideLayouts/slideLayout72.xml"/><Relationship Id="rId3" Type="http://schemas.openxmlformats.org/officeDocument/2006/relationships/slideLayout" Target="../slideLayouts/slideLayout3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46" Type="http://schemas.openxmlformats.org/officeDocument/2006/relationships/slideLayout" Target="../slideLayouts/slideLayout46.xml"/><Relationship Id="rId59" Type="http://schemas.openxmlformats.org/officeDocument/2006/relationships/slideLayout" Target="../slideLayouts/slideLayout59.xml"/><Relationship Id="rId67" Type="http://schemas.openxmlformats.org/officeDocument/2006/relationships/slideLayout" Target="../slideLayouts/slideLayout67.xml"/><Relationship Id="rId20" Type="http://schemas.openxmlformats.org/officeDocument/2006/relationships/slideLayout" Target="../slideLayouts/slideLayout20.xml"/><Relationship Id="rId41" Type="http://schemas.openxmlformats.org/officeDocument/2006/relationships/slideLayout" Target="../slideLayouts/slideLayout41.xml"/><Relationship Id="rId54" Type="http://schemas.openxmlformats.org/officeDocument/2006/relationships/slideLayout" Target="../slideLayouts/slideLayout54.xml"/><Relationship Id="rId62" Type="http://schemas.openxmlformats.org/officeDocument/2006/relationships/slideLayout" Target="../slideLayouts/slideLayout62.xml"/><Relationship Id="rId70" Type="http://schemas.openxmlformats.org/officeDocument/2006/relationships/slideLayout" Target="../slideLayouts/slideLayout70.xml"/><Relationship Id="rId75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49" Type="http://schemas.openxmlformats.org/officeDocument/2006/relationships/slideLayout" Target="../slideLayouts/slideLayout49.xml"/><Relationship Id="rId57" Type="http://schemas.openxmlformats.org/officeDocument/2006/relationships/slideLayout" Target="../slideLayouts/slideLayout57.xml"/><Relationship Id="rId10" Type="http://schemas.openxmlformats.org/officeDocument/2006/relationships/slideLayout" Target="../slideLayouts/slideLayout10.xml"/><Relationship Id="rId31" Type="http://schemas.openxmlformats.org/officeDocument/2006/relationships/slideLayout" Target="../slideLayouts/slideLayout31.xml"/><Relationship Id="rId44" Type="http://schemas.openxmlformats.org/officeDocument/2006/relationships/slideLayout" Target="../slideLayouts/slideLayout44.xml"/><Relationship Id="rId52" Type="http://schemas.openxmlformats.org/officeDocument/2006/relationships/slideLayout" Target="../slideLayouts/slideLayout52.xml"/><Relationship Id="rId60" Type="http://schemas.openxmlformats.org/officeDocument/2006/relationships/slideLayout" Target="../slideLayouts/slideLayout60.xml"/><Relationship Id="rId65" Type="http://schemas.openxmlformats.org/officeDocument/2006/relationships/slideLayout" Target="../slideLayouts/slideLayout65.xml"/><Relationship Id="rId73" Type="http://schemas.openxmlformats.org/officeDocument/2006/relationships/slideLayout" Target="../slideLayouts/slideLayout7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9" Type="http://schemas.openxmlformats.org/officeDocument/2006/relationships/slideLayout" Target="../slideLayouts/slideLayout39.xml"/><Relationship Id="rId34" Type="http://schemas.openxmlformats.org/officeDocument/2006/relationships/slideLayout" Target="../slideLayouts/slideLayout34.xml"/><Relationship Id="rId50" Type="http://schemas.openxmlformats.org/officeDocument/2006/relationships/slideLayout" Target="../slideLayouts/slideLayout50.xml"/><Relationship Id="rId55" Type="http://schemas.openxmlformats.org/officeDocument/2006/relationships/slideLayout" Target="../slideLayouts/slideLayout55.xml"/><Relationship Id="rId7" Type="http://schemas.openxmlformats.org/officeDocument/2006/relationships/slideLayout" Target="../slideLayouts/slideLayout7.xml"/><Relationship Id="rId71" Type="http://schemas.openxmlformats.org/officeDocument/2006/relationships/slideLayout" Target="../slideLayouts/slideLayout7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241741" y="6378130"/>
            <a:ext cx="454745" cy="245223"/>
          </a:xfrm>
          <a:prstGeom prst="rect">
            <a:avLst/>
          </a:prstGeom>
        </p:spPr>
        <p:txBody>
          <a:bodyPr lIns="0" tIns="0" rIns="0" bIns="0" anchor="b"/>
          <a:lstStyle>
            <a:lvl1pPr algn="r">
              <a:defRPr lang="en-US" sz="1000" smtClean="0">
                <a:solidFill>
                  <a:schemeClr val="bg1">
                    <a:lumMod val="75000"/>
                  </a:schemeClr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523A240F-EAFE-E84F-B44C-6D7A08E0E409}" type="slidenum">
              <a:rPr lang="en-US" smtClean="0"/>
              <a:t>‹#›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839199" y="6378130"/>
            <a:ext cx="2241177" cy="245223"/>
          </a:xfrm>
          <a:prstGeom prst="rect">
            <a:avLst/>
          </a:prstGeom>
        </p:spPr>
        <p:txBody>
          <a:bodyPr lIns="0" tIns="0" rIns="0" bIns="0" anchor="b"/>
          <a:lstStyle>
            <a:lvl1pPr algn="r">
              <a:defRPr lang="en-US" sz="1000" smtClean="0">
                <a:solidFill>
                  <a:schemeClr val="bg1">
                    <a:lumMod val="75000"/>
                  </a:schemeClr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r>
              <a:rPr lang="en-US"/>
              <a:t>MSK Confidential — do not distribute</a:t>
            </a: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2063" y="457201"/>
            <a:ext cx="11184423" cy="914400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064" y="1700783"/>
            <a:ext cx="11184422" cy="4404741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8067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  <p:sldLayoutId id="2147483681" r:id="rId21"/>
    <p:sldLayoutId id="2147483682" r:id="rId22"/>
    <p:sldLayoutId id="2147483683" r:id="rId23"/>
    <p:sldLayoutId id="2147483684" r:id="rId24"/>
    <p:sldLayoutId id="2147483685" r:id="rId25"/>
    <p:sldLayoutId id="2147483686" r:id="rId26"/>
    <p:sldLayoutId id="2147483687" r:id="rId27"/>
    <p:sldLayoutId id="2147483688" r:id="rId28"/>
    <p:sldLayoutId id="2147483689" r:id="rId29"/>
    <p:sldLayoutId id="2147483690" r:id="rId30"/>
    <p:sldLayoutId id="2147483691" r:id="rId31"/>
    <p:sldLayoutId id="2147483692" r:id="rId32"/>
    <p:sldLayoutId id="2147483693" r:id="rId33"/>
    <p:sldLayoutId id="2147483694" r:id="rId34"/>
    <p:sldLayoutId id="2147483695" r:id="rId35"/>
    <p:sldLayoutId id="2147483696" r:id="rId36"/>
    <p:sldLayoutId id="2147483697" r:id="rId37"/>
    <p:sldLayoutId id="2147483698" r:id="rId38"/>
    <p:sldLayoutId id="2147483699" r:id="rId39"/>
    <p:sldLayoutId id="2147483700" r:id="rId40"/>
    <p:sldLayoutId id="2147483701" r:id="rId41"/>
    <p:sldLayoutId id="2147483702" r:id="rId42"/>
    <p:sldLayoutId id="2147483703" r:id="rId43"/>
    <p:sldLayoutId id="2147483704" r:id="rId44"/>
    <p:sldLayoutId id="2147483705" r:id="rId45"/>
    <p:sldLayoutId id="2147483706" r:id="rId46"/>
    <p:sldLayoutId id="2147483707" r:id="rId47"/>
    <p:sldLayoutId id="2147483708" r:id="rId48"/>
    <p:sldLayoutId id="2147483709" r:id="rId49"/>
    <p:sldLayoutId id="2147483710" r:id="rId50"/>
    <p:sldLayoutId id="2147483711" r:id="rId51"/>
    <p:sldLayoutId id="2147483712" r:id="rId52"/>
    <p:sldLayoutId id="2147483713" r:id="rId53"/>
    <p:sldLayoutId id="2147483714" r:id="rId54"/>
    <p:sldLayoutId id="2147483715" r:id="rId55"/>
    <p:sldLayoutId id="2147483716" r:id="rId56"/>
    <p:sldLayoutId id="2147483717" r:id="rId57"/>
    <p:sldLayoutId id="2147483718" r:id="rId58"/>
    <p:sldLayoutId id="2147483719" r:id="rId59"/>
    <p:sldLayoutId id="2147483720" r:id="rId60"/>
    <p:sldLayoutId id="2147483721" r:id="rId61"/>
    <p:sldLayoutId id="2147483722" r:id="rId62"/>
    <p:sldLayoutId id="2147483723" r:id="rId63"/>
    <p:sldLayoutId id="2147483724" r:id="rId64"/>
    <p:sldLayoutId id="2147483725" r:id="rId65"/>
    <p:sldLayoutId id="2147483726" r:id="rId66"/>
    <p:sldLayoutId id="2147483727" r:id="rId67"/>
    <p:sldLayoutId id="2147483728" r:id="rId68"/>
    <p:sldLayoutId id="2147483729" r:id="rId69"/>
    <p:sldLayoutId id="2147483730" r:id="rId70"/>
    <p:sldLayoutId id="2147483731" r:id="rId71"/>
    <p:sldLayoutId id="2147483732" r:id="rId72"/>
    <p:sldLayoutId id="2147483733" r:id="rId73"/>
    <p:sldLayoutId id="2147483734" r:id="rId74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200" b="1" kern="1200" spc="-50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Arial" panose="020B0604020202020204" pitchFamily="34" charset="0"/>
        <a:buNone/>
        <a:defRPr sz="1800" kern="1200">
          <a:solidFill>
            <a:srgbClr val="272524"/>
          </a:solidFill>
          <a:latin typeface="+mn-lt"/>
          <a:ea typeface="+mn-ea"/>
          <a:cs typeface="+mn-cs"/>
        </a:defRPr>
      </a:lvl1pPr>
      <a:lvl2pPr marL="2286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•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2pPr>
      <a:lvl3pPr marL="4572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System Font Regular"/>
        <a:buChar char="–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3pPr>
      <a:lvl4pPr marL="6858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•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4pPr>
      <a:lvl5pPr marL="914400" indent="-228600" algn="l" defTabSz="914400" rtl="0" eaLnBrk="1" latinLnBrk="0" hangingPunct="1">
        <a:lnSpc>
          <a:spcPct val="100000"/>
        </a:lnSpc>
        <a:spcBef>
          <a:spcPts val="0"/>
        </a:spcBef>
        <a:spcAft>
          <a:spcPts val="600"/>
        </a:spcAft>
        <a:buFont typeface="System Font Regular"/>
        <a:buChar char="–"/>
        <a:tabLst/>
        <a:defRPr sz="1800" kern="1200">
          <a:solidFill>
            <a:srgbClr val="272524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88">
          <p15:clr>
            <a:srgbClr val="F26B43"/>
          </p15:clr>
        </p15:guide>
        <p15:guide id="2" pos="318">
          <p15:clr>
            <a:srgbClr val="F26B43"/>
          </p15:clr>
        </p15:guide>
        <p15:guide id="3" pos="7370">
          <p15:clr>
            <a:srgbClr val="F26B43"/>
          </p15:clr>
        </p15:guide>
        <p15:guide id="4" orient="horz" pos="4170">
          <p15:clr>
            <a:srgbClr val="F26B43"/>
          </p15:clr>
        </p15:guide>
        <p15:guide id="5" orient="horz" pos="864">
          <p15:clr>
            <a:srgbClr val="F26B43"/>
          </p15:clr>
        </p15:guide>
        <p15:guide id="6" orient="horz" pos="1070">
          <p15:clr>
            <a:srgbClr val="F26B43"/>
          </p15:clr>
        </p15:guide>
        <p15:guide id="7" orient="horz" pos="3846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30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222CE561-EE2F-D978-EEA2-D8C7C657B8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3937" y="495299"/>
            <a:ext cx="4191000" cy="5448300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D11AE950-2925-F290-575D-E9968F18064F}"/>
              </a:ext>
            </a:extLst>
          </p:cNvPr>
          <p:cNvCxnSpPr>
            <a:cxnSpLocks/>
          </p:cNvCxnSpPr>
          <p:nvPr/>
        </p:nvCxnSpPr>
        <p:spPr>
          <a:xfrm>
            <a:off x="5070863" y="5043609"/>
            <a:ext cx="1119656" cy="2317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BF7354F-EEE4-3A96-96BB-958208D1D3E3}"/>
              </a:ext>
            </a:extLst>
          </p:cNvPr>
          <p:cNvCxnSpPr>
            <a:cxnSpLocks/>
            <a:stCxn id="51" idx="3"/>
          </p:cNvCxnSpPr>
          <p:nvPr/>
        </p:nvCxnSpPr>
        <p:spPr>
          <a:xfrm>
            <a:off x="2514654" y="4562498"/>
            <a:ext cx="1463010" cy="33230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D7D4991-0A39-D8BA-9700-D8723AA0B39F}"/>
              </a:ext>
            </a:extLst>
          </p:cNvPr>
          <p:cNvCxnSpPr>
            <a:cxnSpLocks/>
            <a:stCxn id="48" idx="3"/>
          </p:cNvCxnSpPr>
          <p:nvPr/>
        </p:nvCxnSpPr>
        <p:spPr>
          <a:xfrm flipV="1">
            <a:off x="2514655" y="4985696"/>
            <a:ext cx="1753975" cy="3744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2738459-0B09-3A7A-03E5-8360D96E693E}"/>
              </a:ext>
            </a:extLst>
          </p:cNvPr>
          <p:cNvCxnSpPr>
            <a:cxnSpLocks/>
            <a:stCxn id="50" idx="3"/>
          </p:cNvCxnSpPr>
          <p:nvPr/>
        </p:nvCxnSpPr>
        <p:spPr>
          <a:xfrm>
            <a:off x="2514654" y="4157103"/>
            <a:ext cx="1572084" cy="3807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7D236D74-9187-3BED-2C84-13618A2D3C88}"/>
              </a:ext>
            </a:extLst>
          </p:cNvPr>
          <p:cNvCxnSpPr>
            <a:cxnSpLocks/>
          </p:cNvCxnSpPr>
          <p:nvPr/>
        </p:nvCxnSpPr>
        <p:spPr>
          <a:xfrm>
            <a:off x="4085759" y="4537816"/>
            <a:ext cx="101507" cy="2796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AF6B22E-C1AA-7185-71E9-E0A40EEF42AA}"/>
              </a:ext>
            </a:extLst>
          </p:cNvPr>
          <p:cNvCxnSpPr>
            <a:cxnSpLocks/>
            <a:stCxn id="55" idx="3"/>
          </p:cNvCxnSpPr>
          <p:nvPr/>
        </p:nvCxnSpPr>
        <p:spPr>
          <a:xfrm>
            <a:off x="2514654" y="3849551"/>
            <a:ext cx="1563538" cy="6184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5DF08DC-A7B8-8C91-1572-4D5EF1F13087}"/>
              </a:ext>
            </a:extLst>
          </p:cNvPr>
          <p:cNvCxnSpPr>
            <a:cxnSpLocks/>
          </p:cNvCxnSpPr>
          <p:nvPr/>
        </p:nvCxnSpPr>
        <p:spPr>
          <a:xfrm>
            <a:off x="4078192" y="4468025"/>
            <a:ext cx="451245" cy="34940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E633B45-E915-2EF4-814F-26E25F3F4C6C}"/>
              </a:ext>
            </a:extLst>
          </p:cNvPr>
          <p:cNvSpPr txBox="1"/>
          <p:nvPr/>
        </p:nvSpPr>
        <p:spPr>
          <a:xfrm>
            <a:off x="6144476" y="4951370"/>
            <a:ext cx="15180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Hindgut (extends from the distal third of the transverse colon to the cloacal membrane)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DC203E49-573F-26B1-0416-5A8666A8F104}"/>
              </a:ext>
            </a:extLst>
          </p:cNvPr>
          <p:cNvCxnSpPr>
            <a:cxnSpLocks/>
          </p:cNvCxnSpPr>
          <p:nvPr/>
        </p:nvCxnSpPr>
        <p:spPr>
          <a:xfrm flipV="1">
            <a:off x="2514654" y="5108702"/>
            <a:ext cx="2014783" cy="3246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C9AE887D-4908-3815-2572-67E74EC91F82}"/>
              </a:ext>
            </a:extLst>
          </p:cNvPr>
          <p:cNvSpPr txBox="1"/>
          <p:nvPr/>
        </p:nvSpPr>
        <p:spPr>
          <a:xfrm>
            <a:off x="437769" y="4838471"/>
            <a:ext cx="2076886" cy="369332"/>
          </a:xfrm>
          <a:prstGeom prst="rect">
            <a:avLst/>
          </a:prstGeom>
          <a:noFill/>
        </p:spPr>
        <p:txBody>
          <a:bodyPr wrap="square" rIns="0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Cloaca (endoderm-lined; forms anorectal canal, and urogenital sinus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D435A1D-3945-778D-8579-8E2F5320E180}"/>
              </a:ext>
            </a:extLst>
          </p:cNvPr>
          <p:cNvSpPr txBox="1"/>
          <p:nvPr/>
        </p:nvSpPr>
        <p:spPr>
          <a:xfrm>
            <a:off x="437770" y="3972437"/>
            <a:ext cx="2076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Proctodeum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(ectoderm-lined; forms lower 1/3</a:t>
            </a:r>
            <a:r>
              <a:rPr kumimoji="0" lang="en-US" sz="900" b="0" i="0" u="none" strike="noStrike" kern="1200" cap="none" spc="0" normalizeH="0" baseline="3000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rd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of the anal canal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AB1021F-C1BF-65BD-152F-3ADF43F9950E}"/>
              </a:ext>
            </a:extLst>
          </p:cNvPr>
          <p:cNvSpPr txBox="1"/>
          <p:nvPr/>
        </p:nvSpPr>
        <p:spPr>
          <a:xfrm>
            <a:off x="437768" y="4377832"/>
            <a:ext cx="2076886" cy="369332"/>
          </a:xfrm>
          <a:prstGeom prst="rect">
            <a:avLst/>
          </a:prstGeom>
          <a:solidFill>
            <a:srgbClr val="D1E1FF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Tailgut (post-anal gut; normally involutes by the 8</a:t>
            </a:r>
            <a:r>
              <a:rPr kumimoji="0" lang="en-US" sz="900" b="0" i="0" u="none" strike="noStrike" kern="1200" cap="none" spc="0" normalizeH="0" baseline="3000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th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week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53175F9-B4C7-B3C3-5D7D-555298216081}"/>
              </a:ext>
            </a:extLst>
          </p:cNvPr>
          <p:cNvSpPr txBox="1"/>
          <p:nvPr/>
        </p:nvSpPr>
        <p:spPr>
          <a:xfrm>
            <a:off x="437770" y="5258138"/>
            <a:ext cx="22187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Urorectal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septum (mesodermal; grows into cloaca and divides it into urogenital sinus and anal canal; forms perineal body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977F244-AA47-B291-9915-5D959CC8ADD0}"/>
              </a:ext>
            </a:extLst>
          </p:cNvPr>
          <p:cNvSpPr txBox="1"/>
          <p:nvPr/>
        </p:nvSpPr>
        <p:spPr>
          <a:xfrm>
            <a:off x="437770" y="3734135"/>
            <a:ext cx="20768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Future urinary bladder develops her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E9074D1-D915-9BF7-10B1-29944840C18F}"/>
              </a:ext>
            </a:extLst>
          </p:cNvPr>
          <p:cNvSpPr txBox="1"/>
          <p:nvPr/>
        </p:nvSpPr>
        <p:spPr>
          <a:xfrm>
            <a:off x="1831264" y="3454519"/>
            <a:ext cx="6833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llantois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5C9D2FCF-B4E8-8A1C-DF0E-D9E281D6236C}"/>
              </a:ext>
            </a:extLst>
          </p:cNvPr>
          <p:cNvCxnSpPr>
            <a:cxnSpLocks/>
            <a:stCxn id="56" idx="3"/>
          </p:cNvCxnSpPr>
          <p:nvPr/>
        </p:nvCxnSpPr>
        <p:spPr>
          <a:xfrm>
            <a:off x="2514654" y="3569935"/>
            <a:ext cx="1292788" cy="5085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4A6E75F6-F946-A3D4-18CC-E6FFB35E1212}"/>
              </a:ext>
            </a:extLst>
          </p:cNvPr>
          <p:cNvSpPr txBox="1"/>
          <p:nvPr/>
        </p:nvSpPr>
        <p:spPr>
          <a:xfrm>
            <a:off x="308344" y="223284"/>
            <a:ext cx="117915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Figure S1.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Human embryo during 4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th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week of development (Adapted from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Langman’s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Medical Embryology, 2024).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9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22834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6C6554F-1E4D-504B-4F00-A6C81302F265}"/>
              </a:ext>
            </a:extLst>
          </p:cNvPr>
          <p:cNvSpPr txBox="1"/>
          <p:nvPr/>
        </p:nvSpPr>
        <p:spPr>
          <a:xfrm>
            <a:off x="200246" y="39849"/>
            <a:ext cx="1179150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Figure S2: Myositis and myonecrosis at previously irradiated sites, attributed to gemcitabine-associated radiation recall.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srgbClr val="272524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xial fat-suppressed T2-weighted (T2FS) and post-contrast images of the left shoulder, forearm and hip. Areas of myositis and myonecrosis demonstrated as edema on T2FS and hypo-enhancement on post-contrast images (red arrows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(B) Axial T2FS image of the proximal thighs shows asymmetric thickening and edema of the left sciatic nerve (red arrow). Note normal looking right sciatic nerve (green arrow)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C3CA90-8D5A-42E1-F672-C640FEB99F45}"/>
              </a:ext>
            </a:extLst>
          </p:cNvPr>
          <p:cNvSpPr txBox="1"/>
          <p:nvPr/>
        </p:nvSpPr>
        <p:spPr>
          <a:xfrm>
            <a:off x="833594" y="5173878"/>
            <a:ext cx="14381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Post-contrast MR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EAED8A3-1E5D-7E13-4403-375EF74C4358}"/>
              </a:ext>
            </a:extLst>
          </p:cNvPr>
          <p:cNvSpPr txBox="1"/>
          <p:nvPr/>
        </p:nvSpPr>
        <p:spPr>
          <a:xfrm>
            <a:off x="833594" y="2498019"/>
            <a:ext cx="143817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Fat-suppressed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T2-weighted MR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642A47-CEF9-50A9-EB1E-A27D198059E9}"/>
              </a:ext>
            </a:extLst>
          </p:cNvPr>
          <p:cNvSpPr txBox="1"/>
          <p:nvPr/>
        </p:nvSpPr>
        <p:spPr>
          <a:xfrm>
            <a:off x="3115034" y="1132536"/>
            <a:ext cx="1581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Left Shoul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5CE41A-AFE3-D564-E88F-E1B2BDBAC37A}"/>
              </a:ext>
            </a:extLst>
          </p:cNvPr>
          <p:cNvSpPr txBox="1"/>
          <p:nvPr/>
        </p:nvSpPr>
        <p:spPr>
          <a:xfrm>
            <a:off x="5775619" y="1132536"/>
            <a:ext cx="1581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Left Forear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57683DC-B8C1-7292-4541-DF3664632BE6}"/>
              </a:ext>
            </a:extLst>
          </p:cNvPr>
          <p:cNvSpPr txBox="1"/>
          <p:nvPr/>
        </p:nvSpPr>
        <p:spPr>
          <a:xfrm>
            <a:off x="8436204" y="1132536"/>
            <a:ext cx="8384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Left Hip</a:t>
            </a:r>
          </a:p>
        </p:txBody>
      </p:sp>
      <p:pic>
        <p:nvPicPr>
          <p:cNvPr id="24" name="Content Placeholder 4" descr="An x-ray of a fetus&#10;&#10;Description automatically generated">
            <a:extLst>
              <a:ext uri="{FF2B5EF4-FFF2-40B4-BE49-F238E27FC236}">
                <a16:creationId xmlns:a16="http://schemas.microsoft.com/office/drawing/2014/main" id="{174DA1E3-1F56-0C84-D1E9-72EEA9FB449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3447" y="1424329"/>
            <a:ext cx="2503356" cy="2578270"/>
          </a:xfrm>
        </p:spPr>
      </p:pic>
      <p:pic>
        <p:nvPicPr>
          <p:cNvPr id="25" name="Picture 24" descr="An x-ray of a human body&#10;&#10;Description automatically generated">
            <a:extLst>
              <a:ext uri="{FF2B5EF4-FFF2-40B4-BE49-F238E27FC236}">
                <a16:creationId xmlns:a16="http://schemas.microsoft.com/office/drawing/2014/main" id="{3EA257B5-427D-4EDA-DA63-F5250C3DDB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382" y="4146353"/>
            <a:ext cx="2503356" cy="2578270"/>
          </a:xfrm>
          <a:prstGeom prst="rect">
            <a:avLst/>
          </a:prstGeom>
        </p:spPr>
      </p:pic>
      <p:pic>
        <p:nvPicPr>
          <p:cNvPr id="26" name="Picture 25" descr="An x-ray of a human body&#10;&#10;Description automatically generated">
            <a:extLst>
              <a:ext uri="{FF2B5EF4-FFF2-40B4-BE49-F238E27FC236}">
                <a16:creationId xmlns:a16="http://schemas.microsoft.com/office/drawing/2014/main" id="{F5367489-01DB-4B7B-7429-CAE10C4D46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382" y="1424328"/>
            <a:ext cx="2503356" cy="2578270"/>
          </a:xfrm>
          <a:prstGeom prst="rect">
            <a:avLst/>
          </a:prstGeom>
        </p:spPr>
      </p:pic>
      <p:pic>
        <p:nvPicPr>
          <p:cNvPr id="27" name="Picture 26" descr="A close up of a body&#10;&#10;Description automatically generated">
            <a:extLst>
              <a:ext uri="{FF2B5EF4-FFF2-40B4-BE49-F238E27FC236}">
                <a16:creationId xmlns:a16="http://schemas.microsoft.com/office/drawing/2014/main" id="{DDF2DF39-101B-E544-F263-9062E54804C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2915" y="4146353"/>
            <a:ext cx="2503356" cy="2578270"/>
          </a:xfrm>
          <a:prstGeom prst="rect">
            <a:avLst/>
          </a:prstGeom>
        </p:spPr>
      </p:pic>
      <p:pic>
        <p:nvPicPr>
          <p:cNvPr id="28" name="Picture 27" descr="A close up of a mri&#10;&#10;Description automatically generated">
            <a:extLst>
              <a:ext uri="{FF2B5EF4-FFF2-40B4-BE49-F238E27FC236}">
                <a16:creationId xmlns:a16="http://schemas.microsoft.com/office/drawing/2014/main" id="{18DF784B-C67C-8768-8164-328E3A267C6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2915" y="1424331"/>
            <a:ext cx="2503356" cy="2578270"/>
          </a:xfrm>
          <a:prstGeom prst="rect">
            <a:avLst/>
          </a:prstGeom>
        </p:spPr>
      </p:pic>
      <p:pic>
        <p:nvPicPr>
          <p:cNvPr id="29" name="Picture 28" descr="An x-ray of a person's body&#10;&#10;Description automatically generated">
            <a:extLst>
              <a:ext uri="{FF2B5EF4-FFF2-40B4-BE49-F238E27FC236}">
                <a16:creationId xmlns:a16="http://schemas.microsoft.com/office/drawing/2014/main" id="{86B0C083-C636-0B16-9B5D-06E8DC0B382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3447" y="4146353"/>
            <a:ext cx="2503356" cy="2578271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792E67F1-825D-C398-189F-B640316F4B93}"/>
              </a:ext>
            </a:extLst>
          </p:cNvPr>
          <p:cNvSpPr txBox="1"/>
          <p:nvPr/>
        </p:nvSpPr>
        <p:spPr>
          <a:xfrm>
            <a:off x="365686" y="1141739"/>
            <a:ext cx="5921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2663965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9E8BECA-180B-F4AD-616F-03874FB6B650}"/>
              </a:ext>
            </a:extLst>
          </p:cNvPr>
          <p:cNvSpPr txBox="1"/>
          <p:nvPr/>
        </p:nvSpPr>
        <p:spPr>
          <a:xfrm>
            <a:off x="3174131" y="985216"/>
            <a:ext cx="5921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272524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(B)</a:t>
            </a:r>
          </a:p>
        </p:txBody>
      </p:sp>
      <p:pic>
        <p:nvPicPr>
          <p:cNvPr id="6" name="Picture 5" descr="An x-ray of a human body&#10;&#10;Description automatically generated">
            <a:extLst>
              <a:ext uri="{FF2B5EF4-FFF2-40B4-BE49-F238E27FC236}">
                <a16:creationId xmlns:a16="http://schemas.microsoft.com/office/drawing/2014/main" id="{F6FC6023-E96F-849B-6139-BCF3AFDFD9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2463" y="985216"/>
            <a:ext cx="4696148" cy="4746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5364407"/>
      </p:ext>
    </p:extLst>
  </p:cSld>
  <p:clrMapOvr>
    <a:masterClrMapping/>
  </p:clrMapOvr>
</p:sld>
</file>

<file path=ppt/theme/theme1.xml><?xml version="1.0" encoding="utf-8"?>
<a:theme xmlns:a="http://schemas.openxmlformats.org/drawingml/2006/main" name="MSK Internal Template">
  <a:themeElements>
    <a:clrScheme name="MSK Direct">
      <a:dk1>
        <a:srgbClr val="002569"/>
      </a:dk1>
      <a:lt1>
        <a:srgbClr val="FFFFFF"/>
      </a:lt1>
      <a:dk2>
        <a:srgbClr val="272524"/>
      </a:dk2>
      <a:lt2>
        <a:srgbClr val="FBF9F7"/>
      </a:lt2>
      <a:accent1>
        <a:srgbClr val="0073E0"/>
      </a:accent1>
      <a:accent2>
        <a:srgbClr val="70BCFF"/>
      </a:accent2>
      <a:accent3>
        <a:srgbClr val="C3DEFF"/>
      </a:accent3>
      <a:accent4>
        <a:srgbClr val="037D98"/>
      </a:accent4>
      <a:accent5>
        <a:srgbClr val="78E2DA"/>
      </a:accent5>
      <a:accent6>
        <a:srgbClr val="B1FFF9"/>
      </a:accent6>
      <a:hlink>
        <a:srgbClr val="3259E7"/>
      </a:hlink>
      <a:folHlink>
        <a:srgbClr val="863ECC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none" rtlCol="0">
        <a:spAutoFit/>
      </a:bodyPr>
      <a:lstStyle>
        <a:defPPr algn="l">
          <a:defRPr dirty="0" smtClean="0">
            <a:solidFill>
              <a:srgbClr val="272524"/>
            </a:solidFill>
          </a:defRPr>
        </a:defPPr>
      </a:lstStyle>
    </a:txDef>
  </a:objectDefaults>
  <a:extraClrSchemeLst/>
  <a:custClrLst>
    <a:custClr name="Dark Warm Gray">
      <a:srgbClr val="272524"/>
    </a:custClr>
    <a:custClr name="Blue">
      <a:srgbClr val="0073E0"/>
    </a:custClr>
    <a:custClr name="Dark Teal">
      <a:srgbClr val="037D98"/>
    </a:custClr>
    <a:custClr name="Dark Green">
      <a:srgbClr val="308229"/>
    </a:custClr>
    <a:custClr name="Dark Orange">
      <a:srgbClr val="E65722"/>
    </a:custClr>
    <a:custClr name="Dark Gold">
      <a:srgbClr val="C28110"/>
    </a:custClr>
    <a:custClr name="Dark Pink">
      <a:srgbClr val="D71D77"/>
    </a:custClr>
    <a:custClr name="Dark Purple">
      <a:srgbClr val="863ECC"/>
    </a:custClr>
    <a:custClr name="White01">
      <a:srgbClr val="FFFFFF"/>
    </a:custClr>
    <a:custClr name="Utility Red">
      <a:srgbClr val="E40D00"/>
    </a:custClr>
    <a:custClr name="Medium Warm Gray">
      <a:srgbClr val="B5B2AD"/>
    </a:custClr>
    <a:custClr name="Medium Blue">
      <a:srgbClr val="70BCFF"/>
    </a:custClr>
    <a:custClr name="Teal">
      <a:srgbClr val="78E2DA"/>
    </a:custClr>
    <a:custClr name="Green">
      <a:srgbClr val="5DCC6F"/>
    </a:custClr>
    <a:custClr name="Orange">
      <a:srgbClr val="FF8834"/>
    </a:custClr>
    <a:custClr name="Gold">
      <a:srgbClr val="FFBE02"/>
    </a:custClr>
    <a:custClr name="Pink">
      <a:srgbClr val="FF85BF"/>
    </a:custClr>
    <a:custClr name="Purple">
      <a:srgbClr val="BD8AEF"/>
    </a:custClr>
    <a:custClr name="White02">
      <a:srgbClr val="FFFFFF"/>
    </a:custClr>
    <a:custClr name="Utility Light Red">
      <a:srgbClr val="FFEDE8"/>
    </a:custClr>
    <a:custClr name="White03">
      <a:srgbClr val="FFFFFF"/>
    </a:custClr>
    <a:custClr name="Light Blue">
      <a:srgbClr val="C3DEFF"/>
    </a:custClr>
    <a:custClr name="Light Teal">
      <a:srgbClr val="B1FFF9"/>
    </a:custClr>
    <a:custClr name="Light Green">
      <a:srgbClr val="C7FCC6"/>
    </a:custClr>
    <a:custClr name="Light Orange">
      <a:srgbClr val="FCD2B4"/>
    </a:custClr>
    <a:custClr name="Light Gold">
      <a:srgbClr val="FFEDBA"/>
    </a:custClr>
    <a:custClr name="Light Pink">
      <a:srgbClr val="FFBBEC"/>
    </a:custClr>
    <a:custClr name="Light Purple">
      <a:srgbClr val="F4BDFF"/>
    </a:custClr>
    <a:custClr name="White04">
      <a:srgbClr val="FFFFFF"/>
    </a:custClr>
    <a:custClr name="Utility Dark Green">
      <a:srgbClr val="008937"/>
    </a:custClr>
    <a:custClr name="Pale Warm Gray">
      <a:srgbClr val="FBF9F7"/>
    </a:custClr>
    <a:custClr name="Pale Blue">
      <a:srgbClr val="F0F7FF"/>
    </a:custClr>
    <a:custClr name="Pale Teal">
      <a:srgbClr val="EBFCFA"/>
    </a:custClr>
    <a:custClr name="White05">
      <a:srgbClr val="FFFFFF"/>
    </a:custClr>
    <a:custClr name="White06">
      <a:srgbClr val="FFFFFF"/>
    </a:custClr>
    <a:custClr name="White07">
      <a:srgbClr val="FFFFFF"/>
    </a:custClr>
    <a:custClr name="White08">
      <a:srgbClr val="FFFFFF"/>
    </a:custClr>
    <a:custClr name="White09">
      <a:srgbClr val="FFFFFF"/>
    </a:custClr>
    <a:custClr name="White10">
      <a:srgbClr val="FFFFFF"/>
    </a:custClr>
    <a:custClr name="Utility Light Green">
      <a:srgbClr val="E4FFE3"/>
    </a:custClr>
  </a:custClrLst>
  <a:extLst>
    <a:ext uri="{05A4C25C-085E-4340-85A3-A5531E510DB2}">
      <thm15:themeFamily xmlns:thm15="http://schemas.microsoft.com/office/thememl/2012/main" name="MSK_Internal_Template" id="{59C23CD5-9955-5D4B-8670-B804478838D9}" vid="{943BE80A-EBCC-7E4F-9C4C-522D1ECDE113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B0306E0E11EAA4DB461FC8B09FCE607" ma:contentTypeVersion="11" ma:contentTypeDescription="Create a new document." ma:contentTypeScope="" ma:versionID="070d7116e767b82cc229549620c67f39">
  <xsd:schema xmlns:xsd="http://www.w3.org/2001/XMLSchema" xmlns:xs="http://www.w3.org/2001/XMLSchema" xmlns:p="http://schemas.microsoft.com/office/2006/metadata/properties" xmlns:ns3="f65bd33f-4642-4d95-937d-1ab46361a753" targetNamespace="http://schemas.microsoft.com/office/2006/metadata/properties" ma:root="true" ma:fieldsID="2d52545cf71a402e086db34055b84329" ns3:_="">
    <xsd:import namespace="f65bd33f-4642-4d95-937d-1ab46361a75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DateTaken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65bd33f-4642-4d95-937d-1ab46361a75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14" nillable="true" ma:displayName="_activity" ma:hidden="true" ma:internalName="_activity">
      <xsd:simpleType>
        <xsd:restriction base="dms:Note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16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18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65bd33f-4642-4d95-937d-1ab46361a753" xsi:nil="true"/>
  </documentManagement>
</p:properties>
</file>

<file path=customXml/itemProps1.xml><?xml version="1.0" encoding="utf-8"?>
<ds:datastoreItem xmlns:ds="http://schemas.openxmlformats.org/officeDocument/2006/customXml" ds:itemID="{54C8D2E7-3B58-4DA6-896C-E90DB591C4E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DC53FED-0BA5-4169-825F-131A4AE08A0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65bd33f-4642-4d95-937d-1ab46361a75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5C51236-C4B4-4E14-A09B-CAE31AE9B544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f65bd33f-4642-4d95-937d-1ab46361a753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206</Words>
  <Application>Microsoft Office PowerPoint</Application>
  <PresentationFormat>Widescreen</PresentationFormat>
  <Paragraphs>20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System Font Regular</vt:lpstr>
      <vt:lpstr>Times</vt:lpstr>
      <vt:lpstr>MSK Internal Templat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srat, Maliha</dc:creator>
  <cp:lastModifiedBy>Nusrat, Maliha</cp:lastModifiedBy>
  <cp:revision>1</cp:revision>
  <dcterms:created xsi:type="dcterms:W3CDTF">2025-03-21T03:48:14Z</dcterms:created>
  <dcterms:modified xsi:type="dcterms:W3CDTF">2025-10-13T23:09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B0306E0E11EAA4DB461FC8B09FCE607</vt:lpwstr>
  </property>
</Properties>
</file>